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handoutMasterIdLst>
    <p:handoutMasterId r:id="rId10"/>
  </p:handoutMasterIdLst>
  <p:sldIdLst>
    <p:sldId id="259" r:id="rId2"/>
    <p:sldId id="257" r:id="rId3"/>
    <p:sldId id="268" r:id="rId4"/>
    <p:sldId id="262" r:id="rId5"/>
    <p:sldId id="265" r:id="rId6"/>
    <p:sldId id="266" r:id="rId7"/>
    <p:sldId id="267" r:id="rId8"/>
  </p:sldIdLst>
  <p:sldSz cx="6858000" cy="9144000" type="letter"/>
  <p:notesSz cx="6858000" cy="9296400"/>
  <p:custDataLst>
    <p:tags r:id="rId12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91" autoAdjust="0"/>
    <p:restoredTop sz="97212" autoAdjust="0"/>
  </p:normalViewPr>
  <p:slideViewPr>
    <p:cSldViewPr>
      <p:cViewPr>
        <p:scale>
          <a:sx n="110" d="100"/>
          <a:sy n="110" d="100"/>
        </p:scale>
        <p:origin x="-1384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79" d="100"/>
          <a:sy n="79" d="100"/>
        </p:scale>
        <p:origin x="-1998" y="-90"/>
      </p:cViewPr>
      <p:guideLst>
        <p:guide orient="horz" pos="2928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tags" Target="tags/tag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AB1F29-D459-4480-AC8F-6A18A9540A13}" type="datetimeFigureOut">
              <a:rPr lang="en-US" smtClean="0"/>
              <a:pPr/>
              <a:t>15-06-0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CD5EDD-2A8A-4D3D-80D2-AB52B175A7C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5242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BFC27D-9A8C-48F3-8B03-2B61EF3F3D6F}" type="datetimeFigureOut">
              <a:rPr lang="en-US" smtClean="0"/>
              <a:pPr/>
              <a:t>15-06-0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6425"/>
            <a:ext cx="548640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861261-60EA-41B1-8C74-162BEA09B6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45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61261-60EA-41B1-8C74-162BEA09B64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0345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61261-60EA-41B1-8C74-162BEA09B643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0507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61261-60EA-41B1-8C74-162BEA09B64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4263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61261-60EA-41B1-8C74-162BEA09B64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03458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861261-60EA-41B1-8C74-162BEA09B643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0345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5906562" y="0"/>
            <a:ext cx="1020401" cy="357051"/>
          </a:xfrm>
        </p:spPr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408754" y="347978"/>
            <a:ext cx="6122409" cy="62484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3" name="Rectangle 32"/>
          <p:cNvSpPr/>
          <p:nvPr/>
        </p:nvSpPr>
        <p:spPr>
          <a:xfrm>
            <a:off x="228600" y="8153400"/>
            <a:ext cx="6400800" cy="669471"/>
          </a:xfrm>
          <a:prstGeom prst="rect">
            <a:avLst/>
          </a:prstGeom>
          <a:noFill/>
          <a:ln w="6350" cap="rnd" cmpd="sng" algn="ctr">
            <a:solidFill>
              <a:schemeClr val="accent2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2" name="Rectangle 21"/>
          <p:cNvSpPr/>
          <p:nvPr/>
        </p:nvSpPr>
        <p:spPr>
          <a:xfrm>
            <a:off x="228600" y="347978"/>
            <a:ext cx="406107" cy="624840"/>
          </a:xfrm>
          <a:prstGeom prst="rect">
            <a:avLst/>
          </a:prstGeom>
          <a:solidFill>
            <a:schemeClr val="accent1"/>
          </a:solidFill>
          <a:ln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" name="Rectangle 1"/>
          <p:cNvSpPr/>
          <p:nvPr userDrawn="1"/>
        </p:nvSpPr>
        <p:spPr>
          <a:xfrm>
            <a:off x="609735" y="347978"/>
            <a:ext cx="1453541" cy="624840"/>
          </a:xfrm>
          <a:prstGeom prst="rect">
            <a:avLst/>
          </a:prstGeom>
          <a:ln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 userDrawn="1"/>
        </p:nvSpPr>
        <p:spPr>
          <a:xfrm>
            <a:off x="1773581" y="347978"/>
            <a:ext cx="4766055" cy="622150"/>
          </a:xfrm>
          <a:prstGeom prst="rect">
            <a:avLst/>
          </a:prstGeom>
          <a:ln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/>
          <p:cNvSpPr/>
          <p:nvPr userDrawn="1"/>
        </p:nvSpPr>
        <p:spPr>
          <a:xfrm>
            <a:off x="499579" y="275677"/>
            <a:ext cx="1347347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 smtClean="0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</a:rPr>
              <a:t>OSI</a:t>
            </a:r>
            <a:endParaRPr lang="en-US" sz="4400" b="1" cap="none" spc="0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5" name="TextBox 4"/>
          <p:cNvSpPr txBox="1"/>
          <p:nvPr userDrawn="1"/>
        </p:nvSpPr>
        <p:spPr>
          <a:xfrm>
            <a:off x="1882368" y="475732"/>
            <a:ext cx="4770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TTAWA</a:t>
            </a:r>
            <a:r>
              <a:rPr lang="en-US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SELF-INJURY INVENTORY</a:t>
            </a:r>
            <a:endParaRPr lang="en-US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304800" y="8153400"/>
            <a:ext cx="617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43450" y="406400"/>
            <a:ext cx="1885950" cy="1117600"/>
          </a:xfrm>
        </p:spPr>
        <p:txBody>
          <a:bodyPr anchor="b" anchorCtr="0">
            <a:noAutofit/>
          </a:bodyPr>
          <a:lstStyle>
            <a:lvl1pPr algn="l">
              <a:buNone/>
              <a:defRPr sz="2000" b="1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4743450" y="1625601"/>
            <a:ext cx="1885950" cy="6457951"/>
          </a:xfrm>
        </p:spPr>
        <p:txBody>
          <a:bodyPr/>
          <a:lstStyle>
            <a:lvl1pPr marL="0" indent="0">
              <a:lnSpc>
                <a:spcPts val="2200"/>
              </a:lnSpc>
              <a:spcAft>
                <a:spcPts val="1000"/>
              </a:spcAft>
              <a:buNone/>
              <a:defRPr sz="1600">
                <a:solidFill>
                  <a:schemeClr val="tx2"/>
                </a:solidFill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Straight Connector 7"/>
          <p:cNvSpPr>
            <a:spLocks noChangeShapeType="1"/>
          </p:cNvSpPr>
          <p:nvPr/>
        </p:nvSpPr>
        <p:spPr bwMode="auto">
          <a:xfrm>
            <a:off x="342900" y="84709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Straight Connector 9"/>
          <p:cNvSpPr>
            <a:spLocks noChangeShapeType="1"/>
          </p:cNvSpPr>
          <p:nvPr/>
        </p:nvSpPr>
        <p:spPr bwMode="auto">
          <a:xfrm rot="5400000">
            <a:off x="610264" y="4432300"/>
            <a:ext cx="804672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Isosceles Triangle 8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"/>
          </p:nvPr>
        </p:nvSpPr>
        <p:spPr>
          <a:xfrm>
            <a:off x="228600" y="406400"/>
            <a:ext cx="4286250" cy="762000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667808"/>
            <a:ext cx="6172200" cy="899584"/>
          </a:xfrm>
          <a:ln>
            <a:solidFill>
              <a:schemeClr val="accent1"/>
            </a:solidFill>
          </a:ln>
        </p:spPr>
        <p:txBody>
          <a:bodyPr lIns="274320" anchor="ctr"/>
          <a:lstStyle>
            <a:lvl1pPr algn="r">
              <a:buNone/>
              <a:defRPr sz="2000" b="0">
                <a:solidFill>
                  <a:schemeClr val="tx1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42900" y="2540000"/>
            <a:ext cx="6172200" cy="5693664"/>
          </a:xfrm>
          <a:solidFill>
            <a:schemeClr val="tx1">
              <a:shade val="50000"/>
            </a:schemeClr>
          </a:solidFill>
          <a:ln>
            <a:noFill/>
          </a:ln>
          <a:effectLst/>
        </p:spPr>
        <p:txBody>
          <a:bodyPr/>
          <a:lstStyle>
            <a:lvl1pPr marL="0" indent="0">
              <a:spcBef>
                <a:spcPts val="600"/>
              </a:spcBef>
              <a:buNone/>
              <a:defRPr sz="3200"/>
            </a:lvl1pPr>
          </a:lstStyle>
          <a:p>
            <a:r>
              <a:rPr kumimoji="0" lang="en-US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625600"/>
            <a:ext cx="6172200" cy="711200"/>
          </a:xfrm>
        </p:spPr>
        <p:txBody>
          <a:bodyPr anchor="ctr" anchorCtr="0"/>
          <a:lstStyle>
            <a:lvl1pPr marL="0" indent="0" algn="l">
              <a:buFontTx/>
              <a:buNone/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Straight Connector 7"/>
          <p:cNvSpPr>
            <a:spLocks noChangeShapeType="1"/>
          </p:cNvSpPr>
          <p:nvPr/>
        </p:nvSpPr>
        <p:spPr bwMode="auto">
          <a:xfrm>
            <a:off x="342900" y="84709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Isosceles Triangle 8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Rectangle 9"/>
          <p:cNvSpPr/>
          <p:nvPr/>
        </p:nvSpPr>
        <p:spPr>
          <a:xfrm>
            <a:off x="342900" y="667808"/>
            <a:ext cx="137160" cy="91440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Straight Connector 6"/>
          <p:cNvSpPr>
            <a:spLocks noChangeShapeType="1"/>
          </p:cNvSpPr>
          <p:nvPr/>
        </p:nvSpPr>
        <p:spPr bwMode="auto">
          <a:xfrm>
            <a:off x="342900" y="84709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8" name="Isosceles Triangle 7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9" name="Straight Connector 8"/>
          <p:cNvSpPr>
            <a:spLocks noChangeShapeType="1"/>
          </p:cNvSpPr>
          <p:nvPr/>
        </p:nvSpPr>
        <p:spPr bwMode="auto">
          <a:xfrm rot="5400000">
            <a:off x="1015325" y="4269269"/>
            <a:ext cx="780288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/>
          <p:cNvSpPr/>
          <p:nvPr/>
        </p:nvSpPr>
        <p:spPr>
          <a:xfrm>
            <a:off x="390525" y="8402067"/>
            <a:ext cx="6076950" cy="578184"/>
          </a:xfrm>
          <a:prstGeom prst="rect">
            <a:avLst/>
          </a:prstGeom>
          <a:noFill/>
          <a:ln w="6350" cap="rnd" cmpd="sng" algn="ctr">
            <a:solidFill>
              <a:schemeClr val="accent2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5" name="TextBox 4"/>
          <p:cNvSpPr txBox="1"/>
          <p:nvPr userDrawn="1"/>
        </p:nvSpPr>
        <p:spPr>
          <a:xfrm>
            <a:off x="1402131" y="88374"/>
            <a:ext cx="477006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</a:t>
            </a:r>
            <a:r>
              <a:rPr lang="en-US" sz="14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TAWA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</a:t>
            </a:r>
            <a:r>
              <a:rPr lang="en-US" sz="1400" b="1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S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ELF-INJURY  </a:t>
            </a:r>
            <a:r>
              <a:rPr lang="en-US" sz="1400" b="1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VENTORY</a:t>
            </a:r>
            <a:endParaRPr lang="en-US" sz="14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6" name="TextBox 5"/>
          <p:cNvSpPr txBox="1"/>
          <p:nvPr userDrawn="1"/>
        </p:nvSpPr>
        <p:spPr>
          <a:xfrm>
            <a:off x="295275" y="8379369"/>
            <a:ext cx="61722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6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Mary Kay Nixon, M.D. &amp; Paula Cloutier, M.A.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6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opyright 2005</a:t>
            </a:r>
            <a:endParaRPr lang="en-US" sz="600" i="1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>
              <a:lnSpc>
                <a:spcPct val="100000"/>
              </a:lnSpc>
            </a:pPr>
            <a:endParaRPr lang="en-GB" sz="600" i="0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>
              <a:lnSpc>
                <a:spcPct val="100000"/>
              </a:lnSpc>
            </a:pPr>
            <a:r>
              <a:rPr lang="en-GB" sz="5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Researchers and clinicians working in non-profit or publicly owned settings (including universities, non-profit hospitals, and government institutions) may make single copies of the OSI instrument for their own clinical and research use.  </a:t>
            </a:r>
            <a:endParaRPr lang="en-US" sz="500" i="1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>
              <a:lnSpc>
                <a:spcPct val="100000"/>
              </a:lnSpc>
            </a:pPr>
            <a:r>
              <a:rPr lang="en-GB" sz="6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 </a:t>
            </a:r>
            <a:endParaRPr lang="en-US" sz="600" i="1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>
              <a:lnSpc>
                <a:spcPct val="100000"/>
              </a:lnSpc>
            </a:pPr>
            <a:r>
              <a:rPr lang="en-GB" sz="6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 </a:t>
            </a:r>
            <a:endParaRPr lang="en-US" sz="600" i="1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1" name="TextBox 10"/>
          <p:cNvSpPr txBox="1"/>
          <p:nvPr userDrawn="1"/>
        </p:nvSpPr>
        <p:spPr>
          <a:xfrm>
            <a:off x="533400" y="88374"/>
            <a:ext cx="6172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SI v3.1 English</a:t>
            </a:r>
            <a:endParaRPr lang="en-US" sz="800" i="1" kern="1200" dirty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3" name="Rectangle 22"/>
          <p:cNvSpPr/>
          <p:nvPr userDrawn="1"/>
        </p:nvSpPr>
        <p:spPr>
          <a:xfrm>
            <a:off x="233547" y="805848"/>
            <a:ext cx="1657237" cy="9426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4" name="Rectangle 23"/>
          <p:cNvSpPr/>
          <p:nvPr userDrawn="1"/>
        </p:nvSpPr>
        <p:spPr>
          <a:xfrm>
            <a:off x="233547" y="694944"/>
            <a:ext cx="1657237" cy="9426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5" name="Rectangle 24"/>
          <p:cNvSpPr/>
          <p:nvPr userDrawn="1"/>
        </p:nvSpPr>
        <p:spPr>
          <a:xfrm>
            <a:off x="233547" y="576072"/>
            <a:ext cx="1657237" cy="9426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6" name="Rectangle 25"/>
          <p:cNvSpPr/>
          <p:nvPr userDrawn="1"/>
        </p:nvSpPr>
        <p:spPr>
          <a:xfrm>
            <a:off x="233547" y="457200"/>
            <a:ext cx="1657237" cy="9426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7" name="TextBox 3"/>
          <p:cNvSpPr txBox="1">
            <a:spLocks noChangeArrowheads="1"/>
          </p:cNvSpPr>
          <p:nvPr userDrawn="1"/>
        </p:nvSpPr>
        <p:spPr bwMode="auto">
          <a:xfrm>
            <a:off x="233548" y="-152400"/>
            <a:ext cx="771298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0" dirty="0">
                <a:latin typeface="Century" pitchFamily="18" charset="0"/>
              </a:rPr>
              <a:t>O</a:t>
            </a:r>
          </a:p>
        </p:txBody>
      </p:sp>
      <p:sp>
        <p:nvSpPr>
          <p:cNvPr id="28" name="TextBox 4"/>
          <p:cNvSpPr txBox="1">
            <a:spLocks noChangeArrowheads="1"/>
          </p:cNvSpPr>
          <p:nvPr userDrawn="1"/>
        </p:nvSpPr>
        <p:spPr bwMode="auto">
          <a:xfrm>
            <a:off x="910627" y="-152400"/>
            <a:ext cx="650628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0" dirty="0">
                <a:latin typeface="Century" pitchFamily="18" charset="0"/>
              </a:rPr>
              <a:t>S</a:t>
            </a:r>
          </a:p>
        </p:txBody>
      </p:sp>
      <p:sp>
        <p:nvSpPr>
          <p:cNvPr id="29" name="TextBox 5"/>
          <p:cNvSpPr txBox="1">
            <a:spLocks noChangeArrowheads="1"/>
          </p:cNvSpPr>
          <p:nvPr userDrawn="1"/>
        </p:nvSpPr>
        <p:spPr bwMode="auto">
          <a:xfrm>
            <a:off x="1419297" y="-152400"/>
            <a:ext cx="471488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0" dirty="0">
                <a:latin typeface="Century" pitchFamily="18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19218998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 userDrawn="1"/>
        </p:nvSpPr>
        <p:spPr>
          <a:xfrm flipV="1">
            <a:off x="267608" y="290877"/>
            <a:ext cx="785972" cy="4571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9" name="Rectangle 28"/>
          <p:cNvSpPr/>
          <p:nvPr userDrawn="1"/>
        </p:nvSpPr>
        <p:spPr>
          <a:xfrm flipV="1">
            <a:off x="267608" y="239262"/>
            <a:ext cx="785972" cy="4571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0" name="Rectangle 29"/>
          <p:cNvSpPr/>
          <p:nvPr userDrawn="1"/>
        </p:nvSpPr>
        <p:spPr>
          <a:xfrm flipV="1">
            <a:off x="267608" y="187647"/>
            <a:ext cx="785972" cy="4571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1" name="Rectangle 30"/>
          <p:cNvSpPr/>
          <p:nvPr userDrawn="1"/>
        </p:nvSpPr>
        <p:spPr>
          <a:xfrm flipV="1">
            <a:off x="267608" y="131573"/>
            <a:ext cx="785972" cy="4571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6" name="TextBox 5"/>
          <p:cNvSpPr txBox="1"/>
          <p:nvPr userDrawn="1"/>
        </p:nvSpPr>
        <p:spPr>
          <a:xfrm>
            <a:off x="457200" y="91842"/>
            <a:ext cx="6172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SI v3.1 English</a:t>
            </a:r>
            <a:endParaRPr lang="en-US" sz="800" i="1" kern="1200" dirty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6" name="TextBox 3"/>
          <p:cNvSpPr txBox="1">
            <a:spLocks noChangeArrowheads="1"/>
          </p:cNvSpPr>
          <p:nvPr userDrawn="1"/>
        </p:nvSpPr>
        <p:spPr bwMode="auto">
          <a:xfrm>
            <a:off x="1750198" y="1416599"/>
            <a:ext cx="385649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2800" dirty="0">
              <a:latin typeface="Century" pitchFamily="18" charset="0"/>
            </a:endParaRPr>
          </a:p>
        </p:txBody>
      </p:sp>
      <p:sp>
        <p:nvSpPr>
          <p:cNvPr id="27" name="TextBox 4"/>
          <p:cNvSpPr txBox="1">
            <a:spLocks noChangeArrowheads="1"/>
          </p:cNvSpPr>
          <p:nvPr userDrawn="1"/>
        </p:nvSpPr>
        <p:spPr bwMode="auto">
          <a:xfrm>
            <a:off x="457200" y="-95228"/>
            <a:ext cx="650628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800" dirty="0">
                <a:latin typeface="Century" pitchFamily="18" charset="0"/>
              </a:rPr>
              <a:t>S</a:t>
            </a:r>
          </a:p>
        </p:txBody>
      </p:sp>
      <p:sp>
        <p:nvSpPr>
          <p:cNvPr id="28" name="TextBox 5"/>
          <p:cNvSpPr txBox="1">
            <a:spLocks noChangeArrowheads="1"/>
          </p:cNvSpPr>
          <p:nvPr userDrawn="1"/>
        </p:nvSpPr>
        <p:spPr bwMode="auto">
          <a:xfrm>
            <a:off x="660205" y="-95228"/>
            <a:ext cx="471488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800" dirty="0">
                <a:latin typeface="Century" pitchFamily="18" charset="0"/>
              </a:rPr>
              <a:t>I</a:t>
            </a:r>
          </a:p>
        </p:txBody>
      </p:sp>
      <p:sp>
        <p:nvSpPr>
          <p:cNvPr id="2" name="Rectangle 1"/>
          <p:cNvSpPr/>
          <p:nvPr userDrawn="1"/>
        </p:nvSpPr>
        <p:spPr>
          <a:xfrm>
            <a:off x="225406" y="-95228"/>
            <a:ext cx="46358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2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entury" pitchFamily="18" charset="0"/>
              </a:rPr>
              <a:t>O</a:t>
            </a:r>
            <a:endParaRPr kumimoji="0" lang="en-US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entury" pitchFamily="18" charset="0"/>
            </a:endParaRPr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381000" y="8534400"/>
            <a:ext cx="602299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 userDrawn="1"/>
        </p:nvSpPr>
        <p:spPr>
          <a:xfrm>
            <a:off x="2441258" y="8798534"/>
            <a:ext cx="205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8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ixon</a:t>
            </a:r>
            <a:r>
              <a:rPr lang="en-GB" sz="800" i="0" kern="1200" baseline="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8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&amp; Cloutier, 2005 </a:t>
            </a:r>
            <a:endParaRPr lang="en-US" sz="800" i="1" kern="1200" dirty="0" smtClean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3" name="TextBox 12"/>
          <p:cNvSpPr txBox="1"/>
          <p:nvPr userDrawn="1"/>
        </p:nvSpPr>
        <p:spPr>
          <a:xfrm>
            <a:off x="457200" y="88374"/>
            <a:ext cx="6172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i="0" kern="1200" dirty="0" smtClean="0"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SI v3.1 English</a:t>
            </a:r>
            <a:endParaRPr lang="en-US" sz="800" i="1" kern="1200" dirty="0"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5" name="TextBox 14"/>
          <p:cNvSpPr txBox="1"/>
          <p:nvPr userDrawn="1"/>
        </p:nvSpPr>
        <p:spPr>
          <a:xfrm>
            <a:off x="1131693" y="48923"/>
            <a:ext cx="477006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</a:t>
            </a:r>
            <a:r>
              <a:rPr lang="en-US" sz="14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TAWA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</a:t>
            </a:r>
            <a:r>
              <a:rPr lang="en-US" sz="1400" b="1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S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ELF-INJURY  </a:t>
            </a:r>
            <a:r>
              <a:rPr lang="en-US" sz="1400" b="1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</a:t>
            </a:r>
            <a:r>
              <a:rPr lang="en-US" sz="1400" baseline="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VENTORY</a:t>
            </a:r>
            <a:endParaRPr lang="en-US" sz="14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530786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342900" y="1625600"/>
            <a:ext cx="6172200" cy="658368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0" y="3962400"/>
            <a:ext cx="5143500" cy="1422400"/>
          </a:xfrm>
        </p:spPr>
        <p:txBody>
          <a:bodyPr anchor="t" anchorCtr="0"/>
          <a:lstStyle>
            <a:lvl1pPr algn="r">
              <a:buNone/>
              <a:defRPr sz="3200" b="0" cap="none" baseline="0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550" y="5689600"/>
            <a:ext cx="5086350" cy="1524000"/>
          </a:xfrm>
        </p:spPr>
        <p:txBody>
          <a:bodyPr anchor="t" anchorCtr="0"/>
          <a:lstStyle>
            <a:lvl1pPr marL="0" indent="0" algn="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800600" y="8473440"/>
            <a:ext cx="1714500" cy="48768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173986" y="8473440"/>
            <a:ext cx="2606040" cy="487680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02386" y="8473440"/>
            <a:ext cx="1140714" cy="487680"/>
          </a:xfrm>
        </p:spPr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685800" y="3759200"/>
            <a:ext cx="5486400" cy="1706880"/>
          </a:xfrm>
          <a:prstGeom prst="rect">
            <a:avLst/>
          </a:prstGeom>
          <a:noFill/>
          <a:ln w="6350" cap="rnd" cmpd="sng" algn="ctr">
            <a:solidFill>
              <a:schemeClr val="accent1"/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Rectangle 7"/>
          <p:cNvSpPr/>
          <p:nvPr/>
        </p:nvSpPr>
        <p:spPr>
          <a:xfrm>
            <a:off x="685800" y="3759200"/>
            <a:ext cx="171450" cy="1706880"/>
          </a:xfrm>
          <a:prstGeom prst="rect">
            <a:avLst/>
          </a:prstGeom>
          <a:solidFill>
            <a:schemeClr val="accent1"/>
          </a:solidFill>
          <a:ln w="635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04800"/>
            <a:ext cx="6172200" cy="1219200"/>
          </a:xfrm>
        </p:spPr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"/>
          </p:nvPr>
        </p:nvSpPr>
        <p:spPr>
          <a:xfrm>
            <a:off x="342900" y="1625600"/>
            <a:ext cx="3031236" cy="658368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3474149" y="1621536"/>
            <a:ext cx="3031236" cy="658368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04800"/>
            <a:ext cx="6172200" cy="1219200"/>
          </a:xfrm>
        </p:spPr>
        <p:txBody>
          <a:bodyPr anchor="ctr"/>
          <a:lstStyle>
            <a:lvl1pPr>
              <a:defRPr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1714500"/>
            <a:ext cx="3030141" cy="914400"/>
          </a:xfrm>
          <a:noFill/>
          <a:ln>
            <a:noFill/>
          </a:ln>
        </p:spPr>
        <p:txBody>
          <a:bodyPr lIns="91440" anchor="b" anchorCtr="0">
            <a:noAutofit/>
          </a:bodyPr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3486151" y="1727200"/>
            <a:ext cx="3031331" cy="914400"/>
          </a:xfrm>
          <a:noFill/>
          <a:ln>
            <a:noFill/>
          </a:ln>
        </p:spPr>
        <p:txBody>
          <a:bodyPr lIns="91440" anchor="b" anchorCtr="0"/>
          <a:lstStyle>
            <a:lvl1pPr marL="0" indent="0">
              <a:buNone/>
              <a:defRPr sz="2400" b="1">
                <a:solidFill>
                  <a:schemeClr val="accent2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342900" y="2844800"/>
            <a:ext cx="3028950" cy="538480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4"/>
          </p:nvPr>
        </p:nvSpPr>
        <p:spPr>
          <a:xfrm>
            <a:off x="3486150" y="2844800"/>
            <a:ext cx="3028950" cy="5384800"/>
          </a:xfrm>
        </p:spPr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04800"/>
            <a:ext cx="6172200" cy="1219200"/>
          </a:xfrm>
        </p:spPr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Isosceles Triangle 5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Straight Connector 4"/>
          <p:cNvSpPr>
            <a:spLocks noChangeShapeType="1"/>
          </p:cNvSpPr>
          <p:nvPr/>
        </p:nvSpPr>
        <p:spPr bwMode="auto">
          <a:xfrm>
            <a:off x="342900" y="84709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Isosceles Triangle 5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342900" y="203200"/>
            <a:ext cx="6172200" cy="1320800"/>
          </a:xfrm>
          <a:prstGeom prst="rect">
            <a:avLst/>
          </a:prstGeom>
        </p:spPr>
        <p:txBody>
          <a:bodyPr vert="horz" anchor="b" anchorCtr="0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342900" y="1625600"/>
            <a:ext cx="6172200" cy="6547104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4800600" y="8475133"/>
            <a:ext cx="1716786" cy="48768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2173986" y="8475133"/>
            <a:ext cx="2628900" cy="48768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459486" y="8475133"/>
            <a:ext cx="1485900" cy="48768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1400">
                <a:solidFill>
                  <a:schemeClr val="tx2"/>
                </a:solidFill>
              </a:defRPr>
            </a:lvl1pPr>
          </a:lstStyle>
          <a:p>
            <a:fld id="{3FFA8AA2-449D-48F9-94BA-87DE08002744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28" name="Straight Connector 27"/>
          <p:cNvSpPr>
            <a:spLocks noChangeShapeType="1"/>
          </p:cNvSpPr>
          <p:nvPr/>
        </p:nvSpPr>
        <p:spPr bwMode="auto">
          <a:xfrm>
            <a:off x="342900" y="84709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9" name="Straight Connector 28"/>
          <p:cNvSpPr>
            <a:spLocks noChangeShapeType="1"/>
          </p:cNvSpPr>
          <p:nvPr/>
        </p:nvSpPr>
        <p:spPr bwMode="auto">
          <a:xfrm>
            <a:off x="342900" y="1524000"/>
            <a:ext cx="6172200" cy="0"/>
          </a:xfrm>
          <a:prstGeom prst="line">
            <a:avLst/>
          </a:prstGeom>
          <a:noFill/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Isosceles Triangle 9"/>
          <p:cNvSpPr>
            <a:spLocks noChangeAspect="1"/>
          </p:cNvSpPr>
          <p:nvPr/>
        </p:nvSpPr>
        <p:spPr>
          <a:xfrm rot="5400000">
            <a:off x="258661" y="8658391"/>
            <a:ext cx="254465" cy="90236"/>
          </a:xfrm>
          <a:prstGeom prst="triangle">
            <a:avLst>
              <a:gd name="adj" fmla="val 50000"/>
            </a:avLst>
          </a:prstGeom>
          <a:solidFill>
            <a:schemeClr val="accent2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72" r:id="rId2"/>
    <p:sldLayoutId id="2147483673" r:id="rId3"/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</p:sldLayoutIdLst>
  <p:timing>
    <p:tnLst>
      <p:par>
        <p:cTn xmlns:p14="http://schemas.microsoft.com/office/powerpoint/2010/main" id="1" dur="indefinite" restart="never" nodeType="tmRoot"/>
      </p:par>
    </p:tnLst>
  </p:timing>
  <p:hf hdr="0" ftr="0" dt="0"/>
  <p:txStyles>
    <p:titleStyle>
      <a:lvl1pPr algn="l" rtl="0" eaLnBrk="1" latinLnBrk="0" hangingPunct="1">
        <a:spcBef>
          <a:spcPct val="0"/>
        </a:spcBef>
        <a:buNone/>
        <a:defRPr kumimoji="0" sz="32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6000"/>
        <a:buFont typeface="Wingdings 3"/>
        <a:buChar char=""/>
        <a:defRPr kumimoji="0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274320" algn="l" rtl="0" eaLnBrk="1" latinLnBrk="0" hangingPunct="1">
        <a:spcBef>
          <a:spcPts val="500"/>
        </a:spcBef>
        <a:buClr>
          <a:schemeClr val="accent2"/>
        </a:buClr>
        <a:buSzPct val="76000"/>
        <a:buFont typeface="Wingdings 3"/>
        <a:buChar char=""/>
        <a:defRPr kumimoji="0" sz="2300" kern="1200">
          <a:solidFill>
            <a:schemeClr val="tx2"/>
          </a:solidFill>
          <a:latin typeface="+mn-lt"/>
          <a:ea typeface="+mn-ea"/>
          <a:cs typeface="+mn-cs"/>
        </a:defRPr>
      </a:lvl2pPr>
      <a:lvl3pPr marL="822960" indent="-228600" algn="l" rtl="0" eaLnBrk="1" latinLnBrk="0" hangingPunct="1">
        <a:spcBef>
          <a:spcPts val="500"/>
        </a:spcBef>
        <a:buClr>
          <a:schemeClr val="bg1">
            <a:shade val="50000"/>
          </a:schemeClr>
        </a:buClr>
        <a:buSzPct val="76000"/>
        <a:buFont typeface="Wingdings 3"/>
        <a:buChar char="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indent="-228600" algn="l" rtl="0" eaLnBrk="1" latinLnBrk="0" hangingPunct="1">
        <a:spcBef>
          <a:spcPts val="400"/>
        </a:spcBef>
        <a:buClr>
          <a:schemeClr val="accent2">
            <a:shade val="75000"/>
          </a:schemeClr>
        </a:buClr>
        <a:buSzPct val="70000"/>
        <a:buFont typeface="Wingdings"/>
        <a:buChar char="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indent="-228600" algn="l" rtl="0" eaLnBrk="1" latinLnBrk="0" hangingPunct="1">
        <a:spcBef>
          <a:spcPts val="300"/>
        </a:spcBef>
        <a:buClr>
          <a:schemeClr val="accent2"/>
        </a:buClr>
        <a:buSzPct val="70000"/>
        <a:buFont typeface="Wingdings"/>
        <a:buChar char="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645920" indent="-182880" algn="l" rtl="0" eaLnBrk="1" latinLnBrk="0" hangingPunct="1">
        <a:spcBef>
          <a:spcPts val="300"/>
        </a:spcBef>
        <a:buClr>
          <a:srgbClr val="9FB8CD">
            <a:shade val="75000"/>
          </a:srgbClr>
        </a:buClr>
        <a:buSzPct val="75000"/>
        <a:buFont typeface="Wingdings 3"/>
        <a:buChar char=""/>
        <a:defRPr kumimoji="0" lang="en-US" sz="1600" kern="1200" smtClean="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rgbClr val="727CA3">
            <a:shade val="75000"/>
          </a:srgb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7pPr>
      <a:lvl8pPr marL="2011680" indent="-182880" algn="l" rtl="0" eaLnBrk="1" latinLnBrk="0" hangingPunct="1">
        <a:spcBef>
          <a:spcPts val="300"/>
        </a:spcBef>
        <a:buClr>
          <a:prstClr val="white">
            <a:shade val="50000"/>
          </a:prstClr>
        </a:buClr>
        <a:buSzPct val="75000"/>
        <a:buFont typeface="Wingdings 3"/>
        <a:buChar char=""/>
        <a:defRPr kumimoji="0" lang="en-US" sz="1400" kern="1200" smtClean="0">
          <a:solidFill>
            <a:schemeClr val="tx1"/>
          </a:solidFill>
          <a:latin typeface="+mn-lt"/>
          <a:ea typeface="+mn-ea"/>
          <a:cs typeface="+mn-cs"/>
        </a:defRPr>
      </a:lvl8pPr>
      <a:lvl9pPr marL="2194560" indent="-182880" algn="l" rtl="0" eaLnBrk="1" latinLnBrk="0" hangingPunct="1">
        <a:spcBef>
          <a:spcPts val="300"/>
        </a:spcBef>
        <a:buClr>
          <a:srgbClr val="9FB8CD"/>
        </a:buClr>
        <a:buSzPct val="75000"/>
        <a:buFont typeface="Wingdings 3"/>
        <a:buChar char=""/>
        <a:defRPr kumimoji="0" lang="en-US" sz="1200" kern="120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1066799"/>
            <a:ext cx="63246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ame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:	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__________________________    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	</a:t>
            </a:r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Sex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:         Male                               Female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GB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oday’s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ate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:	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DD 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MM 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YY 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</a:t>
            </a:r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ate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f Birth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:</a:t>
            </a:r>
            <a:r>
              <a:rPr lang="en-GB" sz="900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D 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MM </a:t>
            </a:r>
            <a:r>
              <a:rPr lang="en-GB" sz="900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YY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</a:t>
            </a:r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ge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:  </a:t>
            </a:r>
            <a:r>
              <a:rPr lang="en-GB" sz="900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3539822"/>
              </p:ext>
            </p:extLst>
          </p:nvPr>
        </p:nvGraphicFramePr>
        <p:xfrm>
          <a:off x="228600" y="1752600"/>
          <a:ext cx="6324600" cy="1108075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818626"/>
                <a:gridCol w="2505974"/>
              </a:tblGrid>
              <a:tr h="6096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ow 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ften in the past </a:t>
                      </a:r>
                      <a:r>
                        <a:rPr lang="en-GB" sz="900" u="sng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onth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have you</a:t>
                      </a:r>
                      <a:r>
                        <a:rPr lang="en-GB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:</a:t>
                      </a: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US" sz="800" i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ircle  “0” if not at all and circle “3” if daily</a:t>
                      </a:r>
                      <a:endParaRPr lang="en-US" sz="800" b="0" i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ot </a:t>
                      </a: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t all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t least once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eek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ai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i="1" u="sng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ought</a:t>
                      </a:r>
                      <a:r>
                        <a:rPr lang="en-GB" sz="8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bout injuring yourself without the intention to kill yourself? </a:t>
                      </a:r>
                      <a:endParaRPr lang="en-US" sz="11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0               1               2           3          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75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i="1" u="sng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ctually injured </a:t>
                      </a: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yourself, without the intention to kill yourself?</a:t>
                      </a:r>
                      <a:endParaRPr lang="en-US" sz="11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0               1               2           3      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000689"/>
              </p:ext>
            </p:extLst>
          </p:nvPr>
        </p:nvGraphicFramePr>
        <p:xfrm>
          <a:off x="228600" y="2971800"/>
          <a:ext cx="6324600" cy="1111394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818626"/>
                <a:gridCol w="2505974"/>
              </a:tblGrid>
              <a:tr h="57799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ow often in the past </a:t>
                      </a:r>
                      <a:r>
                        <a:rPr lang="en-US" sz="900" u="sng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6 months </a:t>
                      </a: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ave you:</a:t>
                      </a: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US" sz="800" b="0" i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ircle  “0” if not at all and circle “4” if dail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ot </a:t>
                      </a: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t all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to 5 time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onth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eek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ai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i="1" u="sng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ought</a:t>
                      </a:r>
                      <a:r>
                        <a:rPr lang="en-GB" sz="8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bout injuring yourself without the intention to kill yourself?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   1             2           3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i="1" u="sng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ctually injured </a:t>
                      </a: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yourself, without the intention to kill yourself?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0               1             2           3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575736"/>
              </p:ext>
            </p:extLst>
          </p:nvPr>
        </p:nvGraphicFramePr>
        <p:xfrm>
          <a:off x="228600" y="4222522"/>
          <a:ext cx="6324600" cy="914400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818626"/>
                <a:gridCol w="2505974"/>
              </a:tblGrid>
              <a:tr h="6096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ow often in the past </a:t>
                      </a:r>
                      <a:r>
                        <a:rPr lang="en-US" sz="900" i="0" u="sng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year</a:t>
                      </a: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have you:</a:t>
                      </a: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US" sz="800" i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ircle  “0” if not at all and circle “4” if daily</a:t>
                      </a:r>
                      <a:endParaRPr lang="en-US" sz="800" b="0" i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1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ot </a:t>
                      </a: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t all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to 5 time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onth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eek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aily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i="1" u="sng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ought </a:t>
                      </a:r>
                      <a:r>
                        <a:rPr lang="en-US" sz="800" b="0" i="0" u="none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bout taking your life (killing yourself)? </a:t>
                      </a:r>
                      <a:endParaRPr lang="en-US" sz="800" b="0" i="0" u="none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</a:t>
                      </a:r>
                      <a:r>
                        <a:rPr lang="en-GB" sz="8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   1             2           3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28600" y="5212080"/>
            <a:ext cx="6324600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ave you ever made an actual attempt to take your life?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</a:t>
            </a: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</a:t>
            </a: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o</a:t>
            </a: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</a:p>
          <a:p>
            <a:endParaRPr lang="en-US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US" sz="900" i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es, then please indicate the number of times: </a:t>
            </a:r>
          </a:p>
          <a:p>
            <a:endParaRPr lang="en-US" sz="900" i="1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n the past month: </a:t>
            </a: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      in the past 6 months: </a:t>
            </a: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     in the past year:  ____     prior to one year ago: ____</a:t>
            </a:r>
          </a:p>
          <a:p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0940" y="6228575"/>
            <a:ext cx="63246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ave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you ever been treated by a doctor after injuring yourself on purpose? (e.g., stitches, wound dressings, etc.)</a:t>
            </a:r>
            <a:endParaRPr lang="en-US" sz="9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 				</a:t>
            </a:r>
          </a:p>
          <a:p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US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es, 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ow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ften did a doctor treat you in the </a:t>
            </a:r>
            <a:r>
              <a:rPr lang="en-GB" sz="8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ast year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for hurting yourself on purpose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?____________________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ime(s)</a:t>
            </a:r>
            <a:r>
              <a:rPr lang="en-US" sz="800" dirty="0" smtClean="0"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144" y="1708606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144" y="2991534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144" y="4248150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3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144" y="5212080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4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144" y="6235214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5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4050792" y="5238124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5550408" y="5234509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4050792" y="650646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343400" y="1053464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5"/>
          <p:cNvSpPr>
            <a:spLocks noChangeArrowheads="1"/>
          </p:cNvSpPr>
          <p:nvPr/>
        </p:nvSpPr>
        <p:spPr bwMode="auto">
          <a:xfrm>
            <a:off x="230372" y="7246523"/>
            <a:ext cx="6475228" cy="877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r>
              <a:rPr kumimoji="0" lang="en-GB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ave you been kept in hospital because of hurting yourself on purpose? </a:t>
            </a:r>
            <a:endParaRPr kumimoji="0" lang="en-US" altLang="en-US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037013" algn="l"/>
                <a:tab pos="4572000" algn="l"/>
                <a:tab pos="5029200" algn="l"/>
                <a:tab pos="548640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									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037013" algn="l"/>
                <a:tab pos="4572000" algn="l"/>
                <a:tab pos="5029200" algn="l"/>
                <a:tab pos="548640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46" name="Rectangle 45"/>
          <p:cNvSpPr>
            <a:spLocks noChangeArrowheads="1"/>
          </p:cNvSpPr>
          <p:nvPr/>
        </p:nvSpPr>
        <p:spPr bwMode="auto">
          <a:xfrm>
            <a:off x="273110" y="7800520"/>
            <a:ext cx="632105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r>
              <a:rPr lang="en-GB" alt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es,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ow many times in the </a:t>
            </a:r>
            <a:r>
              <a:rPr kumimoji="0" lang="en-GB" altLang="en-US" sz="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ast year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did you stay overnight in emergency? __________________________________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0" algn="l"/>
                <a:tab pos="285750" algn="l"/>
                <a:tab pos="914400" algn="l"/>
                <a:tab pos="1371600" algn="l"/>
                <a:tab pos="1828800" algn="l"/>
                <a:tab pos="20574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</a:tabLst>
            </a:pPr>
            <a:r>
              <a:rPr lang="en-GB" alt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es,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ow many times in the </a:t>
            </a:r>
            <a:r>
              <a:rPr kumimoji="0" lang="en-GB" altLang="en-US" sz="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ast year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did you get admitted to a hospital unit?_________________________________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050792" y="746966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9144" y="7254216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6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524625" y="8839200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5485020" y="650633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5461555" y="746966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5760720" y="103632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233672" y="6538137"/>
            <a:ext cx="414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o</a:t>
            </a:r>
            <a:endParaRPr lang="en-US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5697057" y="6538137"/>
            <a:ext cx="438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yes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267200" y="7467600"/>
            <a:ext cx="414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o</a:t>
            </a:r>
            <a:endParaRPr lang="en-US" sz="800" dirty="0"/>
          </a:p>
        </p:txBody>
      </p:sp>
      <p:sp>
        <p:nvSpPr>
          <p:cNvPr id="28" name="TextBox 27"/>
          <p:cNvSpPr txBox="1"/>
          <p:nvPr/>
        </p:nvSpPr>
        <p:spPr>
          <a:xfrm>
            <a:off x="5638800" y="7467600"/>
            <a:ext cx="438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yes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791200" y="5257800"/>
            <a:ext cx="438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yes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993541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4526219" y="1363614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238825" y="667170"/>
            <a:ext cx="6496751" cy="10926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ou indicated that you had thought about or actually injured yourself in questions 1-4: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</a:t>
            </a:r>
            <a:r>
              <a:rPr lang="en-US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w old were you when you started to self-injure? 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_______________________________ (years old)</a:t>
            </a:r>
          </a:p>
          <a:p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US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US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he first time you hurt yourself, where did you get the idea?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  </a:t>
            </a:r>
            <a:r>
              <a:rPr lang="en-US" sz="12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only one)</a:t>
            </a:r>
          </a:p>
          <a:p>
            <a:endParaRPr lang="en-US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4051" y="1679211"/>
            <a:ext cx="37240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read about it on an internet website</a:t>
            </a:r>
          </a:p>
          <a:p>
            <a:pPr>
              <a:lnSpc>
                <a:spcPct val="200000"/>
              </a:lnSpc>
            </a:pP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I read about it on a Web Blog</a:t>
            </a:r>
          </a:p>
          <a:p>
            <a:pPr>
              <a:lnSpc>
                <a:spcPct val="200000"/>
              </a:lnSpc>
            </a:pP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I read about it in a book or magazine</a:t>
            </a:r>
          </a:p>
          <a:p>
            <a:pPr>
              <a:lnSpc>
                <a:spcPct val="200000"/>
              </a:lnSpc>
            </a:pP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I saw it happen in a movie or on television</a:t>
            </a:r>
          </a:p>
          <a:p>
            <a:pPr>
              <a:lnSpc>
                <a:spcPct val="200000"/>
              </a:lnSpc>
            </a:pP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I saw other people do it in a non-hospital setting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78419" y="1640094"/>
            <a:ext cx="555551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heard about it from other people in a non-hospital setting</a:t>
            </a:r>
          </a:p>
          <a:p>
            <a:pPr>
              <a:lnSpc>
                <a:spcPct val="200000"/>
              </a:lnSpc>
            </a:pP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heard about it from other people in a hospital setting	</a:t>
            </a:r>
          </a:p>
          <a:p>
            <a:pPr>
              <a:lnSpc>
                <a:spcPct val="200000"/>
              </a:lnSpc>
            </a:pP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saw other people do it in a hospital setting</a:t>
            </a:r>
          </a:p>
          <a:p>
            <a:pPr>
              <a:lnSpc>
                <a:spcPct val="200000"/>
              </a:lnSpc>
            </a:pP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</a:t>
            </a:r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 was my own idea	</a:t>
            </a:r>
          </a:p>
          <a:p>
            <a:pPr>
              <a:lnSpc>
                <a:spcPct val="200000"/>
              </a:lnSpc>
            </a:pP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Other (please list)__________________________________</a:t>
            </a:r>
          </a:p>
        </p:txBody>
      </p:sp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8459964"/>
              </p:ext>
            </p:extLst>
          </p:nvPr>
        </p:nvGraphicFramePr>
        <p:xfrm>
          <a:off x="287231" y="3587013"/>
          <a:ext cx="6257925" cy="991209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200400"/>
                <a:gridCol w="3057525"/>
              </a:tblGrid>
              <a:tr h="3810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hen you get the urge to hurt yourself</a:t>
                      </a:r>
                      <a:r>
                        <a:rPr lang="en-GB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: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  <a:defRPr/>
                      </a:pPr>
                      <a:endParaRPr kumimoji="0" lang="en-GB" altLang="en-US" sz="800" b="0" i="1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  <a:defRPr/>
                      </a:pPr>
                      <a:r>
                        <a:rPr kumimoji="0" lang="en-GB" altLang="en-US" sz="8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ircle “0” if not at all and circle “4” if extremely</a:t>
                      </a:r>
                      <a:endParaRPr kumimoji="0" lang="en-US" altLang="en-US" sz="3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Not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t all               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omewhat           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tremel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e urge is distressing / upsetting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     0             1             2            3   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e urge is comforting</a:t>
                      </a:r>
                      <a:endParaRPr lang="en-US" sz="800" b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     0             1             2            3   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e urge is intrusive / invasive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     0             1             2            3             4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9" name="Rectangle 12"/>
          <p:cNvSpPr>
            <a:spLocks noChangeArrowheads="1"/>
          </p:cNvSpPr>
          <p:nvPr/>
        </p:nvSpPr>
        <p:spPr bwMode="auto">
          <a:xfrm>
            <a:off x="184556" y="4933131"/>
            <a:ext cx="6398621" cy="19851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kumimoji="0" lang="en-GB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o you </a:t>
            </a:r>
            <a:r>
              <a:rPr kumimoji="0" lang="en-GB" altLang="en-US" sz="900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nly</a:t>
            </a:r>
            <a:r>
              <a:rPr kumimoji="0" lang="en-GB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harm yourself after taking drugs or alcohol?</a:t>
            </a:r>
            <a:r>
              <a:rPr kumimoji="0" lang="en-GB" altLang="en-US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kumimoji="0" lang="en-GB" altLang="en-US" sz="8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o                		 yes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lang="en-US" altLang="en-US" sz="9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kumimoji="0" lang="en-US" altLang="en-US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o you let other people know that you harm yourself?</a:t>
            </a:r>
            <a:endParaRPr kumimoji="0" lang="en-US" altLang="en-US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endParaRPr kumimoji="0" lang="en-GB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no one					</a:t>
            </a:r>
          </a:p>
          <a:p>
            <a:pPr marL="0" marR="0" lvl="0" indent="0" algn="l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some people   </a:t>
            </a: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o do you tell? 	</a:t>
            </a:r>
          </a:p>
          <a:p>
            <a:pPr marL="0" marR="0" lvl="0" indent="0" algn="l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most people				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" name="Rectangle 15"/>
          <p:cNvSpPr>
            <a:spLocks noChangeArrowheads="1"/>
          </p:cNvSpPr>
          <p:nvPr/>
        </p:nvSpPr>
        <p:spPr bwMode="auto">
          <a:xfrm>
            <a:off x="2659319" y="6142407"/>
            <a:ext cx="3669594" cy="1354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friend(s) 	                                            family member(s)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psychologist/psychiatrist		                          family doctor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other Mental Health Professional	</a:t>
            </a: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school counsellor 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telephone helpline					                          other (specify)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750" algn="l"/>
                <a:tab pos="1028700" algn="l"/>
                <a:tab pos="1657350" algn="l"/>
                <a:tab pos="1828800" algn="l"/>
                <a:tab pos="2114550" algn="l"/>
                <a:tab pos="2628900" algn="l"/>
                <a:tab pos="2971800" algn="l"/>
                <a:tab pos="4400550" algn="l"/>
                <a:tab pos="4572000" algn="l"/>
                <a:tab pos="5772150" algn="l"/>
              </a:tabLst>
            </a:pPr>
            <a:r>
              <a: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						</a:t>
            </a:r>
            <a:endParaRPr kumimoji="0" lang="en-US" alt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1457492" y="6675807"/>
            <a:ext cx="944346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-18349" y="674072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7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18349" y="1376949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8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35219" y="178928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335219" y="200998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40934" y="226907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346649" y="251662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346649" y="2752114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3283584" y="172289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3283584" y="197216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3283584" y="2207283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3283584" y="2449093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3283584" y="2691154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3903216" y="510019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5486400" y="510540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2884650" y="621860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2884650" y="647006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2884650" y="6728075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2884650" y="6962478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5074859" y="621860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5074859" y="647006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5074859" y="6728075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371380" y="621860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371380" y="6470067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371380" y="6728075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-18526" y="3587013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9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-18730" y="5100191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0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-16612" y="5761607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1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-10819" y="-462409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8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583177" y="8839200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</a:t>
            </a:r>
          </a:p>
        </p:txBody>
      </p:sp>
      <p:sp>
        <p:nvSpPr>
          <p:cNvPr id="39" name="Rectangle 38"/>
          <p:cNvSpPr/>
          <p:nvPr/>
        </p:nvSpPr>
        <p:spPr>
          <a:xfrm>
            <a:off x="5074859" y="6962478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331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6942"/>
              </p:ext>
            </p:extLst>
          </p:nvPr>
        </p:nvGraphicFramePr>
        <p:xfrm>
          <a:off x="665989" y="1321098"/>
          <a:ext cx="2321543" cy="5059679"/>
        </p:xfrm>
        <a:graphic>
          <a:graphicData uri="http://schemas.openxmlformats.org/drawingml/2006/table">
            <a:tbl>
              <a:tblPr>
                <a:tableStyleId>{69012ECD-51FC-41F1-AA8D-1B2483CD663E}</a:tableStyleId>
              </a:tblPr>
              <a:tblGrid>
                <a:gridCol w="968231"/>
                <a:gridCol w="612648"/>
                <a:gridCol w="740664"/>
              </a:tblGrid>
              <a:tr h="473987">
                <a:tc>
                  <a:txBody>
                    <a:bodyPr/>
                    <a:lstStyle/>
                    <a:p>
                      <a:pPr marL="71755" marR="71755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6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6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</a:t>
                      </a:r>
                    </a:p>
                    <a:p>
                      <a:pPr algn="ctr"/>
                      <a:r>
                        <a:rPr lang="en-US" sz="800" b="0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HEN YOU FIRST STARTED</a:t>
                      </a: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160270" algn="l"/>
                        </a:tabLst>
                      </a:pPr>
                      <a:endParaRPr lang="en-US" sz="800" b="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160270" algn="l"/>
                        </a:tabLst>
                      </a:pPr>
                      <a:r>
                        <a:rPr lang="en-US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URRENTLY (past month if</a:t>
                      </a:r>
                      <a:r>
                        <a:rPr lang="en-US" sz="800" b="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still self-injuring)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74295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calp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ye(s)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ar(s)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ace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ose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	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ip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nside of mouth 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eck/throat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hest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reast(s)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ack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houlder(s)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bdomen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	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ips/buttock(s)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Genital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ctum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Upper arm/elbow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ower arm/wrist 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and/fingers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igh/knee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ower leg/ankle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oot/toes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1336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US" sz="700" baseline="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ther (specify):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GB" sz="700" baseline="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6664546"/>
              </p:ext>
            </p:extLst>
          </p:nvPr>
        </p:nvGraphicFramePr>
        <p:xfrm>
          <a:off x="3305829" y="1661160"/>
          <a:ext cx="3178032" cy="4206239"/>
        </p:xfrm>
        <a:graphic>
          <a:graphicData uri="http://schemas.openxmlformats.org/drawingml/2006/table">
            <a:tbl>
              <a:tblPr>
                <a:tableStyleId>{69012ECD-51FC-41F1-AA8D-1B2483CD663E}</a:tableStyleId>
              </a:tblPr>
              <a:tblGrid>
                <a:gridCol w="1828800"/>
                <a:gridCol w="609600"/>
                <a:gridCol w="739632"/>
              </a:tblGrid>
              <a:tr h="473987">
                <a:tc>
                  <a:txBody>
                    <a:bodyPr/>
                    <a:lstStyle/>
                    <a:p>
                      <a:pPr marL="71755" marR="71755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6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6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</a:t>
                      </a:r>
                    </a:p>
                    <a:p>
                      <a:pPr algn="ctr"/>
                      <a:r>
                        <a:rPr lang="en-US" sz="800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HEN YOU FIRST STARTED</a:t>
                      </a: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160270" algn="l"/>
                        </a:tabLst>
                      </a:pPr>
                      <a:endParaRPr lang="en-US" sz="8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160270" algn="l"/>
                        </a:tabLst>
                      </a:pPr>
                      <a:r>
                        <a:rPr lang="en-US" sz="8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URRENTLY (past month if</a:t>
                      </a:r>
                      <a:r>
                        <a:rPr lang="en-US" sz="8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still self-injuring)</a:t>
                      </a:r>
                      <a:endParaRPr lang="en-US" sz="8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utt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cratch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nterfering with wound heal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urn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iting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	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itt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air pull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evere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nail biting and/or nail injurie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iercing skin with sharp pointy object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iercing of body part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cessive use of street drug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cessive use of alcohol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rying to break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ones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	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err="1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eadbang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aking too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much medication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aking too little medication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ating or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drinking things that are not food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36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ther (specify):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GB" sz="700" baseline="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75513" y="457200"/>
            <a:ext cx="221187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at areas of your body did/do you injure?  </a:t>
            </a:r>
          </a:p>
          <a:p>
            <a:pPr>
              <a:lnSpc>
                <a:spcPct val="150000"/>
              </a:lnSpc>
            </a:pPr>
            <a:r>
              <a:rPr lang="en-US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lease (</a:t>
            </a:r>
            <a:r>
              <a:rPr lang="en-US" sz="12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US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all that apply</a:t>
            </a:r>
            <a:endParaRPr lang="en-US" i="1" dirty="0"/>
          </a:p>
        </p:txBody>
      </p:sp>
      <p:sp>
        <p:nvSpPr>
          <p:cNvPr id="7" name="Rectangle 6"/>
          <p:cNvSpPr/>
          <p:nvPr/>
        </p:nvSpPr>
        <p:spPr>
          <a:xfrm>
            <a:off x="3581398" y="411033"/>
            <a:ext cx="25241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ow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id/do you injure yourself (without meaning to kill yourself</a:t>
            </a:r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? </a:t>
            </a:r>
            <a:r>
              <a:rPr lang="en-GB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lease (</a:t>
            </a:r>
            <a:r>
              <a:rPr lang="en-US" sz="1400" b="1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GB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</a:t>
            </a:r>
            <a:r>
              <a:rPr lang="en-GB" sz="9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ll that </a:t>
            </a:r>
            <a:r>
              <a:rPr lang="en-GB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pply</a:t>
            </a:r>
            <a:endParaRPr lang="en-US" sz="9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72542" y="481461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2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17455" y="477957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3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35803" y="477957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01503" y="481461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93882" y="6642556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b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455818" y="6154982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b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553200" y="8839200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3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799064" y="6578144"/>
            <a:ext cx="2211871" cy="507831"/>
            <a:chOff x="799064" y="6578144"/>
            <a:chExt cx="2211871" cy="507831"/>
          </a:xfrm>
        </p:grpSpPr>
        <p:sp>
          <p:nvSpPr>
            <p:cNvPr id="14" name="TextBox 13"/>
            <p:cNvSpPr txBox="1"/>
            <p:nvPr/>
          </p:nvSpPr>
          <p:spPr>
            <a:xfrm>
              <a:off x="799064" y="6578144"/>
              <a:ext cx="221187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900" i="1" dirty="0" smtClean="0">
                  <a:latin typeface="Meiryo" panose="020B0604030504040204" pitchFamily="34" charset="-128"/>
                  <a:ea typeface="Meiryo" panose="020B0604030504040204" pitchFamily="34" charset="-128"/>
                  <a:cs typeface="Meiryo" panose="020B0604030504040204" pitchFamily="34" charset="-128"/>
                </a:rPr>
                <a:t>Above, please   circle   the part that you currently injure the most</a:t>
              </a:r>
              <a:endParaRPr lang="en-US" i="1" dirty="0"/>
            </a:p>
          </p:txBody>
        </p:sp>
        <p:sp>
          <p:nvSpPr>
            <p:cNvPr id="4" name="Oval 3"/>
            <p:cNvSpPr/>
            <p:nvPr/>
          </p:nvSpPr>
          <p:spPr>
            <a:xfrm>
              <a:off x="1715732" y="6610923"/>
              <a:ext cx="417868" cy="247077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778779" y="6120055"/>
            <a:ext cx="2524125" cy="507831"/>
            <a:chOff x="3778779" y="6120055"/>
            <a:chExt cx="2524125" cy="507831"/>
          </a:xfrm>
        </p:grpSpPr>
        <p:sp>
          <p:nvSpPr>
            <p:cNvPr id="15" name="Rectangle 14"/>
            <p:cNvSpPr/>
            <p:nvPr/>
          </p:nvSpPr>
          <p:spPr>
            <a:xfrm>
              <a:off x="3778779" y="6120055"/>
              <a:ext cx="2524125" cy="5078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900" i="1" dirty="0" smtClean="0">
                  <a:latin typeface="Meiryo" panose="020B0604030504040204" pitchFamily="34" charset="-128"/>
                  <a:ea typeface="Meiryo" panose="020B0604030504040204" pitchFamily="34" charset="-128"/>
                  <a:cs typeface="Meiryo" panose="020B0604030504040204" pitchFamily="34" charset="-128"/>
                </a:rPr>
                <a:t>Above, please    circle    the method that </a:t>
              </a:r>
              <a:r>
                <a:rPr lang="en-US" sz="900" i="1" dirty="0">
                  <a:latin typeface="Meiryo" panose="020B0604030504040204" pitchFamily="34" charset="-128"/>
                  <a:ea typeface="Meiryo" panose="020B0604030504040204" pitchFamily="34" charset="-128"/>
                  <a:cs typeface="Meiryo" panose="020B0604030504040204" pitchFamily="34" charset="-128"/>
                </a:rPr>
                <a:t>you currently </a:t>
              </a:r>
              <a:r>
                <a:rPr lang="en-US" sz="900" i="1" dirty="0" smtClean="0">
                  <a:latin typeface="Meiryo" panose="020B0604030504040204" pitchFamily="34" charset="-128"/>
                  <a:ea typeface="Meiryo" panose="020B0604030504040204" pitchFamily="34" charset="-128"/>
                  <a:cs typeface="Meiryo" panose="020B0604030504040204" pitchFamily="34" charset="-128"/>
                </a:rPr>
                <a:t>use the </a:t>
              </a:r>
              <a:r>
                <a:rPr lang="en-US" sz="900" i="1" dirty="0">
                  <a:latin typeface="Meiryo" panose="020B0604030504040204" pitchFamily="34" charset="-128"/>
                  <a:ea typeface="Meiryo" panose="020B0604030504040204" pitchFamily="34" charset="-128"/>
                  <a:cs typeface="Meiryo" panose="020B0604030504040204" pitchFamily="34" charset="-128"/>
                </a:rPr>
                <a:t>most</a:t>
              </a:r>
              <a:endParaRPr lang="en-US" sz="900" i="1" dirty="0"/>
            </a:p>
          </p:txBody>
        </p:sp>
        <p:sp>
          <p:nvSpPr>
            <p:cNvPr id="18" name="Oval 17"/>
            <p:cNvSpPr/>
            <p:nvPr/>
          </p:nvSpPr>
          <p:spPr>
            <a:xfrm>
              <a:off x="4724400" y="6153723"/>
              <a:ext cx="417868" cy="247077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</p:spTree>
    <p:extLst>
      <p:ext uri="{BB962C8B-B14F-4D97-AF65-F5344CB8AC3E}">
        <p14:creationId xmlns:p14="http://schemas.microsoft.com/office/powerpoint/2010/main" val="24353069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1263853"/>
              </p:ext>
            </p:extLst>
          </p:nvPr>
        </p:nvGraphicFramePr>
        <p:xfrm>
          <a:off x="260496" y="609600"/>
          <a:ext cx="6302231" cy="7467601"/>
        </p:xfrm>
        <a:graphic>
          <a:graphicData uri="http://schemas.openxmlformats.org/drawingml/2006/table">
            <a:tbl>
              <a:tblPr>
                <a:tableStyleId>{69012ECD-51FC-41F1-AA8D-1B2483CD663E}</a:tableStyleId>
              </a:tblPr>
              <a:tblGrid>
                <a:gridCol w="4395595"/>
                <a:gridCol w="976799"/>
                <a:gridCol w="929837"/>
              </a:tblGrid>
              <a:tr h="1262001">
                <a:tc>
                  <a:txBody>
                    <a:bodyPr/>
                    <a:lstStyle/>
                    <a:p>
                      <a:pPr marL="71755" marR="71755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6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6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Never a reason</a:t>
                      </a: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Sometimes a reason</a:t>
                      </a: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Always a reason</a:t>
                      </a:r>
                    </a:p>
                  </a:txBody>
                  <a:tcPr marL="61722" marR="61722" marT="0" marB="0" vert="vert27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Never a reason</a:t>
                      </a: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Sometimes a reason</a:t>
                      </a:r>
                    </a:p>
                    <a:p>
                      <a:endParaRPr lang="en-US" sz="800" b="1" baseline="0" dirty="0" smtClean="0"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</a:p>
                    <a:p>
                      <a:r>
                        <a:rPr lang="en-US" sz="800" b="1" baseline="0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Always a reason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160270" algn="l"/>
                        </a:tabLst>
                      </a:pPr>
                      <a:endParaRPr lang="en-US" sz="800" b="1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 vert="vert27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4057650" algn="l"/>
                          <a:tab pos="4514850" algn="l"/>
                          <a:tab pos="4972050" algn="l"/>
                          <a:tab pos="5429250" algn="l"/>
                          <a:tab pos="558927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lease unbearable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ension</a:t>
                      </a: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360045" marR="0" indent="-360045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360045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. to </a:t>
                      </a:r>
                      <a:r>
                        <a:rPr lang="en-US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perience a “high”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at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s </a:t>
                      </a:r>
                      <a:r>
                        <a:rPr lang="en-US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ike a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rug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igh</a:t>
                      </a: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3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op my parents from being angry with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e</a:t>
                      </a: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4. to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op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ing alone and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mpty</a:t>
                      </a: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5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get care or attention from other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eople</a:t>
                      </a: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331470" algn="l"/>
                          <a:tab pos="360045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6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unish myself </a:t>
                      </a:r>
                      <a:endParaRPr lang="en-GB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102870" marR="0" indent="-11430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0287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7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rovide a sense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f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citement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at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s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hilarating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1722" marR="6172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8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void getting into trouble for something I did </a:t>
                      </a:r>
                      <a:endParaRPr lang="en-GB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9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istract me from unpleasant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emorie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0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change my body image and/or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ppearance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1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elong to a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group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2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lease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nger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3. t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 show others how hurt or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amaged I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am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360045" marR="0" indent="-360045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360045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4. to </a:t>
                      </a:r>
                      <a:r>
                        <a:rPr lang="en-US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perience physical pain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n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ne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rea, when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e </a:t>
                      </a:r>
                      <a:r>
                        <a:rPr lang="en-US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ther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ain</a:t>
                      </a:r>
                      <a:r>
                        <a:rPr lang="en-US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 </a:t>
                      </a:r>
                      <a:r>
                        <a:rPr lang="en-US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 is </a:t>
                      </a:r>
                      <a:r>
                        <a:rPr lang="en-US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unbearable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5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op people from expecting so much from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e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6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lieve feelings of sadness or feeling “down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”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102870" marR="0" indent="-10287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0287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7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op me from thinking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bout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deas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f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killing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yself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360045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8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op me from acting out ideas of killing myself 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102870" marR="0" indent="-10287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0287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9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roduce a sense of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being real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hen I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umb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nd 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“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unreal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”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0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lease frustration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102870" marR="0" indent="-10287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360045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1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get out of doing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omething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hat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 don’t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ant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o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o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2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rove to myself how much I can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ake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3. for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exual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citement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4. to </a:t>
                      </a:r>
                      <a:r>
                        <a:rPr lang="en-GB" sz="7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iminish feeling of sexual </a:t>
                      </a: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rousal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482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68580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5. other (please specify):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1    2    3    4</a:t>
                      </a:r>
                      <a:endParaRPr lang="en-US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Rectangle 12"/>
          <p:cNvSpPr/>
          <p:nvPr/>
        </p:nvSpPr>
        <p:spPr>
          <a:xfrm>
            <a:off x="260496" y="814603"/>
            <a:ext cx="4525149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y do you think you started and if you continue, why do you still self-injure (without meaning to kill yourself)? </a:t>
            </a:r>
            <a:endParaRPr lang="en-US" sz="900" b="1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GB" sz="800" i="1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i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lease circle the number that best represents how much your self-injury is due to that reason. Circle “0” if it has never been a reason that you self-injure and “4” if it has always been a reason that you self-injure.</a:t>
            </a:r>
            <a:endParaRPr lang="en-US" sz="800" i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525" y="408860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4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521905" y="426935"/>
            <a:ext cx="1371600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y did you start?</a:t>
            </a:r>
            <a:endParaRPr lang="en-US" sz="6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/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5418515" y="360402"/>
            <a:ext cx="13716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ou continue, </a:t>
            </a:r>
          </a:p>
          <a:p>
            <a:pPr algn="ctr"/>
            <a:r>
              <a:rPr lang="en-US" sz="6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y do you continue?</a:t>
            </a:r>
            <a:endParaRPr lang="en-US" sz="6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algn="ctr"/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562727" y="8842248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40470595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40935" y="814967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269535" y="2644497"/>
            <a:ext cx="6324600" cy="1208023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en you hurt yourself on purpose, on average, how much time goes by between thinking about it and doing it?  (Please (</a:t>
            </a:r>
            <a:r>
              <a:rPr lang="en-US" sz="14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1 item only)</a:t>
            </a:r>
          </a:p>
          <a:p>
            <a:endParaRPr lang="en-US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less than 1 minute		</a:t>
            </a: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                   over 30 minutes but less than 1 hour</a:t>
            </a:r>
          </a:p>
          <a:p>
            <a:pPr>
              <a:lnSpc>
                <a:spcPct val="150000"/>
              </a:lnSpc>
            </a:pP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1 minute to 5 minutes		</a:t>
            </a: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                   hours</a:t>
            </a:r>
          </a:p>
          <a:p>
            <a:pPr>
              <a:lnSpc>
                <a:spcPct val="150000"/>
              </a:lnSpc>
            </a:pP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6 minutes to 30 minutes	                        </a:t>
            </a: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days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7642"/>
              </p:ext>
            </p:extLst>
          </p:nvPr>
        </p:nvGraphicFramePr>
        <p:xfrm>
          <a:off x="317160" y="4149015"/>
          <a:ext cx="6324600" cy="719583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733800"/>
                <a:gridCol w="2590800"/>
              </a:tblGrid>
              <a:tr h="536709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1028700" algn="l"/>
                          <a:tab pos="1600200" algn="l"/>
                          <a:tab pos="1828800" algn="l"/>
                          <a:tab pos="2114550" algn="l"/>
                          <a:tab pos="2628900" algn="l"/>
                          <a:tab pos="4400550" algn="l"/>
                          <a:tab pos="4857750" algn="l"/>
                          <a:tab pos="5314950" algn="l"/>
                          <a:tab pos="577215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o you 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feel physical pain when you harm yourself?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Never                 Sometimes            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way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74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 smtClean="0"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</a:t>
                      </a:r>
                      <a:r>
                        <a:rPr lang="en-GB" sz="9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9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</a:t>
                      </a:r>
                      <a:r>
                        <a:rPr lang="en-GB" sz="9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          2          3           4</a:t>
                      </a:r>
                      <a:endParaRPr lang="en-US" sz="12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1" name="Rectangle 20"/>
          <p:cNvSpPr/>
          <p:nvPr/>
        </p:nvSpPr>
        <p:spPr>
          <a:xfrm>
            <a:off x="372405" y="4608884"/>
            <a:ext cx="328614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i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ircle “0” if never and circle “4” if always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9535" y="7211822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69535" y="2230994"/>
            <a:ext cx="641985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nce you think about harming yourself, do you always do it?            yes     		        no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3938565" y="223066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953000" y="220980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463845" y="315585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63845" y="336731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463845" y="3586329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3248955" y="315585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3248955" y="336731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248955" y="3586329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21504" y="2206685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6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1504" y="2644497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7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1504" y="4113388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8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480" y="5190679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9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536985" y="8842248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5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graphicFrame>
        <p:nvGraphicFramePr>
          <p:cNvPr id="37" name="Table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0911536"/>
              </p:ext>
            </p:extLst>
          </p:nvPr>
        </p:nvGraphicFramePr>
        <p:xfrm>
          <a:off x="340020" y="5192634"/>
          <a:ext cx="6324600" cy="719583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733800"/>
                <a:gridCol w="2590800"/>
              </a:tblGrid>
              <a:tr h="536709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1028700" algn="l"/>
                          <a:tab pos="1600200" algn="l"/>
                          <a:tab pos="1828800" algn="l"/>
                          <a:tab pos="2114550" algn="l"/>
                          <a:tab pos="2628900" algn="l"/>
                          <a:tab pos="4400550" algn="l"/>
                          <a:tab pos="4857750" algn="l"/>
                          <a:tab pos="5314950" algn="l"/>
                          <a:tab pos="577215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o you hurt or think about hurting yourself after stressful things happen?  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Never                Sometimes            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way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74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</a:t>
                      </a:r>
                      <a:r>
                        <a:rPr lang="en-GB" sz="9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</a:t>
                      </a: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</a:t>
                      </a:r>
                      <a:r>
                        <a:rPr lang="en-GB" sz="9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          2          3           4</a:t>
                      </a:r>
                      <a:endParaRPr lang="en-US" sz="12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8" name="Rectangle 37"/>
          <p:cNvSpPr/>
          <p:nvPr/>
        </p:nvSpPr>
        <p:spPr>
          <a:xfrm>
            <a:off x="269535" y="6480686"/>
            <a:ext cx="6324600" cy="18928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ou indicated that you thought about or actually injured yourself in questions 1-4</a:t>
            </a:r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, 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at 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kinds of stressful situation(s) typically </a:t>
            </a:r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led </a:t>
            </a:r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o self-injury?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		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abandonment (please specify)_________________________________________________________</a:t>
            </a:r>
          </a:p>
          <a:p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  <a:endParaRPr lang="en-GB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failure (please specify)_______________________________________________________________</a:t>
            </a:r>
          </a:p>
          <a:p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loss (please specify)_________________________________________________________________</a:t>
            </a:r>
          </a:p>
          <a:p>
            <a:r>
              <a:rPr lang="en-GB" sz="9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  <a:endParaRPr lang="en-GB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rejection (please specify)_____________________________________________________________</a:t>
            </a:r>
          </a:p>
          <a:p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other (please specify)________________________________________________________________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498135" y="6056684"/>
            <a:ext cx="7743" cy="3383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436581" y="7009154"/>
            <a:ext cx="182880" cy="1337041"/>
            <a:chOff x="436581" y="6739260"/>
            <a:chExt cx="182880" cy="1337041"/>
          </a:xfrm>
        </p:grpSpPr>
        <p:sp>
          <p:nvSpPr>
            <p:cNvPr id="40" name="Rectangle 39"/>
            <p:cNvSpPr/>
            <p:nvPr/>
          </p:nvSpPr>
          <p:spPr>
            <a:xfrm>
              <a:off x="436581" y="6739260"/>
              <a:ext cx="182880" cy="182880"/>
            </a:xfrm>
            <a:prstGeom prst="rect">
              <a:avLst/>
            </a:prstGeom>
            <a:ln w="12700"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436581" y="6991737"/>
              <a:ext cx="182880" cy="182880"/>
            </a:xfrm>
            <a:prstGeom prst="rect">
              <a:avLst/>
            </a:prstGeom>
            <a:ln w="12700"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436581" y="7290033"/>
              <a:ext cx="182880" cy="182880"/>
            </a:xfrm>
            <a:prstGeom prst="rect">
              <a:avLst/>
            </a:prstGeom>
            <a:ln w="12700"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436581" y="7572412"/>
              <a:ext cx="182880" cy="182880"/>
            </a:xfrm>
            <a:prstGeom prst="rect">
              <a:avLst/>
            </a:prstGeom>
            <a:ln w="12700"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36581" y="7893421"/>
              <a:ext cx="182880" cy="182880"/>
            </a:xfrm>
            <a:prstGeom prst="rect">
              <a:avLst/>
            </a:prstGeom>
            <a:ln w="12700"/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5" name="Rectangle 44"/>
          <p:cNvSpPr/>
          <p:nvPr/>
        </p:nvSpPr>
        <p:spPr>
          <a:xfrm>
            <a:off x="372405" y="5681385"/>
            <a:ext cx="328614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i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ircle “0” if never and circle “4” if always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graphicFrame>
        <p:nvGraphicFramePr>
          <p:cNvPr id="55" name="Table 5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5091583"/>
              </p:ext>
            </p:extLst>
          </p:nvPr>
        </p:nvGraphicFramePr>
        <p:xfrm>
          <a:off x="372405" y="444317"/>
          <a:ext cx="6281379" cy="766069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818626"/>
                <a:gridCol w="2462753"/>
              </a:tblGrid>
              <a:tr h="263753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just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6002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f you indicated that you had thought about or actually injured yourself in questions 1-4</a:t>
                      </a:r>
                      <a:r>
                        <a:rPr lang="en-US" sz="9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, d</a:t>
                      </a: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 you feel relief (better) after </a:t>
                      </a:r>
                      <a:r>
                        <a:rPr lang="en-US" sz="9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arming yourself?</a:t>
                      </a:r>
                      <a:endParaRPr lang="en-US" sz="110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GB" sz="800" b="0" dirty="0" smtClean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71755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ever</a:t>
                      </a:r>
                      <a:r>
                        <a:rPr lang="en-GB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      Sometimes           Alway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US" sz="11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</a:t>
                      </a:r>
                      <a:r>
                        <a:rPr lang="en-GB" sz="8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 1             2           3           4    </a:t>
                      </a:r>
                      <a:endParaRPr lang="en-US" sz="8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6" name="Rectangle 55"/>
          <p:cNvSpPr/>
          <p:nvPr/>
        </p:nvSpPr>
        <p:spPr>
          <a:xfrm>
            <a:off x="402677" y="928151"/>
            <a:ext cx="3429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</a:t>
            </a:r>
            <a:r>
              <a:rPr lang="en-US" sz="800" i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ircle  “0” if never and circle “4” if always</a:t>
            </a:r>
            <a:endParaRPr lang="en-US" sz="800" i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7" name="Rectangle 2"/>
          <p:cNvSpPr>
            <a:spLocks noChangeArrowheads="1"/>
          </p:cNvSpPr>
          <p:nvPr/>
        </p:nvSpPr>
        <p:spPr bwMode="auto">
          <a:xfrm>
            <a:off x="207981" y="-821769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8" name="Rectangle 3"/>
          <p:cNvSpPr>
            <a:spLocks noChangeArrowheads="1"/>
          </p:cNvSpPr>
          <p:nvPr/>
        </p:nvSpPr>
        <p:spPr bwMode="auto">
          <a:xfrm>
            <a:off x="464294" y="757363"/>
            <a:ext cx="6165105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/>
            </a:r>
            <a:br>
              <a: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</a:br>
            <a:endParaRPr lang="en-US" altLang="en-US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GB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f you feel relief, how long does the relief last? </a:t>
            </a:r>
            <a:r>
              <a:rPr lang="en-US" altLang="en-US" sz="4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kumimoji="0" lang="en-GB" altLang="en-US" sz="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(</a:t>
            </a:r>
            <a:r>
              <a:rPr lang="en-US" altLang="en-US" sz="1200" b="1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US" altLang="en-US" sz="800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</a:t>
            </a:r>
            <a:r>
              <a:rPr kumimoji="0" lang="en-GB" altLang="en-US" sz="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nly one)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        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lang="en-GB" altLang="en-US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alt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less than 1minute   </a:t>
            </a: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 to 5 minutes    </a:t>
            </a: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6 to 30 minutes     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342900" algn="l"/>
                <a:tab pos="285750" algn="l"/>
                <a:tab pos="1371600" algn="l"/>
                <a:tab pos="1885950" algn="l"/>
                <a:tab pos="2171700" algn="l"/>
                <a:tab pos="2514600" algn="l"/>
                <a:tab pos="2971800" algn="l"/>
                <a:tab pos="302895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31 to 60 minutes   	           hours	 	 </a:t>
            </a:r>
            <a:r>
              <a:rPr kumimoji="0" lang="en-GB" alt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</a:t>
            </a:r>
            <a:r>
              <a:rPr kumimoji="0" lang="en-GB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days</a:t>
            </a:r>
            <a:endParaRPr kumimoji="0" lang="en-GB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686136" y="160723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686136" y="188155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2036781" y="160723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2036781" y="188155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3290271" y="160723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3290271" y="188155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21504" y="434792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15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8297475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-1" y="-564922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1055597"/>
              </p:ext>
            </p:extLst>
          </p:nvPr>
        </p:nvGraphicFramePr>
        <p:xfrm>
          <a:off x="363259" y="637491"/>
          <a:ext cx="6324600" cy="2921568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675341"/>
                <a:gridCol w="2649259"/>
              </a:tblGrid>
              <a:tr h="442448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1028700" algn="l"/>
                          <a:tab pos="1600200" algn="l"/>
                          <a:tab pos="1828800" algn="l"/>
                          <a:tab pos="2114550" algn="l"/>
                          <a:tab pos="2628900" algn="l"/>
                          <a:tab pos="4400550" algn="l"/>
                          <a:tab pos="4857750" algn="l"/>
                          <a:tab pos="5314950" algn="l"/>
                          <a:tab pos="577215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ince you started to self-injure, have you found that:</a:t>
                      </a: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Never                Sometimes            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lway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15461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.The self-injurious behaviour occurs more often than intended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</a:t>
                      </a: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</a:t>
                      </a:r>
                      <a:r>
                        <a:rPr lang="en-GB" sz="9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6903">
                <a:tc>
                  <a:txBody>
                    <a:bodyPr/>
                    <a:lstStyle/>
                    <a:p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2. The severity in which the self-injurious behaviour occurs has increased (e.g., deeper cuts, more extensive parts of your body)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8897">
                <a:tc>
                  <a:txBody>
                    <a:bodyPr/>
                    <a:lstStyle/>
                    <a:p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3. If the self-injurious behaviour produced an effect when started, you</a:t>
                      </a:r>
                      <a:r>
                        <a:rPr kumimoji="0" lang="en-US" sz="800" b="0" kern="12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ow need to self-injure more frequently or with greater intensity to produce the same effect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1000">
                <a:tc>
                  <a:txBody>
                    <a:bodyPr/>
                    <a:lstStyle/>
                    <a:p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4. This behaviour or thinking about it consumes a significant amount of</a:t>
                      </a:r>
                      <a:r>
                        <a:rPr kumimoji="0" lang="en-US" sz="800" b="0" kern="12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your time (e.g., planning and thinking about it, collecting and hiding sharp objects, doing it and recovering from it)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77996">
                <a:tc>
                  <a:txBody>
                    <a:bodyPr/>
                    <a:lstStyle/>
                    <a:p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5. Despite a desire to cut down or control this behaviour, you are unable to do so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6903">
                <a:tc>
                  <a:txBody>
                    <a:bodyPr/>
                    <a:lstStyle/>
                    <a:p>
                      <a:r>
                        <a:rPr kumimoji="0" lang="en-US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6. You continue this behaviour despite recognizing that it is harmful to you physically and/or emotionally? 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85097">
                <a:tc>
                  <a:txBody>
                    <a:bodyPr/>
                    <a:lstStyle/>
                    <a:p>
                      <a:r>
                        <a:rPr kumimoji="0" lang="en-GB" sz="800" b="0" kern="12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7. Important social, family, academic or recreational activities are given up or reduced because of this behaviour?</a:t>
                      </a:r>
                      <a:endParaRPr lang="en-US" sz="800" b="0" dirty="0" smtClean="0">
                        <a:effectLst/>
                        <a:highlight>
                          <a:srgbClr val="FF0000"/>
                        </a:highlight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1           2          3           4</a:t>
                      </a:r>
                      <a:endParaRPr lang="en-US" sz="9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" name="Rectangle 10"/>
          <p:cNvSpPr/>
          <p:nvPr/>
        </p:nvSpPr>
        <p:spPr>
          <a:xfrm>
            <a:off x="375279" y="858754"/>
            <a:ext cx="40767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i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ircle “0” if never and circle “4” if always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-914401" y="2940278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3466369"/>
              </p:ext>
            </p:extLst>
          </p:nvPr>
        </p:nvGraphicFramePr>
        <p:xfrm>
          <a:off x="1600200" y="4378227"/>
          <a:ext cx="3267074" cy="2743200"/>
        </p:xfrm>
        <a:graphic>
          <a:graphicData uri="http://schemas.openxmlformats.org/drawingml/2006/table">
            <a:tbl>
              <a:tblPr>
                <a:effectLst/>
                <a:tableStyleId>{69012ECD-51FC-41F1-AA8D-1B2483CD663E}</a:tableStyleId>
              </a:tblPr>
              <a:tblGrid>
                <a:gridCol w="2657474"/>
                <a:gridCol w="609600"/>
              </a:tblGrid>
              <a:tr h="228600">
                <a:tc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</a:pPr>
                      <a:endParaRPr lang="en-GB" sz="900" b="1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  <a:defRPr/>
                      </a:pPr>
                      <a:r>
                        <a:rPr lang="en-US" sz="900" b="1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f you are trying to resist hurting yourself, what do you do instead? </a:t>
                      </a:r>
                      <a:r>
                        <a:rPr lang="en-GB" sz="900" i="1" u="sng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Please (</a:t>
                      </a:r>
                      <a:r>
                        <a:rPr lang="en-US" sz="900" b="1" i="1" u="sng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√</a:t>
                      </a:r>
                      <a:r>
                        <a:rPr lang="en-GB" sz="900" i="1" u="sng" dirty="0" smtClean="0"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) all that apply</a:t>
                      </a:r>
                      <a:endParaRPr lang="en-GB" sz="900" b="1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</a:pPr>
                      <a:endParaRPr lang="en-GB" sz="900" b="1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57150" algn="l"/>
                          <a:tab pos="228600" algn="l"/>
                          <a:tab pos="857250" algn="l"/>
                          <a:tab pos="1314450" algn="l"/>
                          <a:tab pos="1600200" algn="l"/>
                          <a:tab pos="2000250" algn="l"/>
                          <a:tab pos="2343150" algn="l"/>
                          <a:tab pos="3143250" algn="l"/>
                          <a:tab pos="3600450" algn="l"/>
                          <a:tab pos="4057650" algn="l"/>
                          <a:tab pos="4514850" algn="l"/>
                          <a:tab pos="4972050" algn="l"/>
                          <a:tab pos="542925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Never try to</a:t>
                      </a:r>
                      <a:r>
                        <a:rPr lang="en-GB" sz="700" baseline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resist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600450" algn="l"/>
                          <a:tab pos="369062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Talk with someone</a:t>
                      </a:r>
                      <a:endParaRPr lang="en-US" sz="11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510915" algn="l"/>
                          <a:tab pos="360045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Exercise / sports</a:t>
                      </a:r>
                      <a:endParaRPr lang="en-US" sz="11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60045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Reading writing, music, dance</a:t>
                      </a:r>
                      <a:endParaRPr lang="en-US" sz="11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Watch television, play video or computer games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60045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o things to relax (e.g., hot bath, yoga, deep breathing)</a:t>
                      </a:r>
                      <a:endParaRPr lang="en-US" sz="11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  <a:defRPr/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Use alcohol and or street drugs</a:t>
                      </a:r>
                      <a:endParaRPr lang="en-US" sz="11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510915" algn="l"/>
                          <a:tab pos="3600450" algn="l"/>
                          <a:tab pos="4680585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o anything to keep hands busy</a:t>
                      </a:r>
                      <a:endParaRPr lang="en-US" sz="11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endParaRPr lang="en-GB" sz="700" dirty="0" smtClean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742950" algn="l"/>
                          <a:tab pos="1371600" algn="l"/>
                          <a:tab pos="3086100" algn="l"/>
                          <a:tab pos="3657600" algn="l"/>
                          <a:tab pos="4114800" algn="l"/>
                          <a:tab pos="4572000" algn="l"/>
                          <a:tab pos="5029200" algn="l"/>
                          <a:tab pos="5486400" algn="l"/>
                        </a:tabLst>
                      </a:pPr>
                      <a:r>
                        <a:rPr lang="en-GB" sz="70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Other (specify): </a:t>
                      </a:r>
                      <a:endParaRPr lang="en-US" sz="7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sz="1600" dirty="0"/>
                    </a:p>
                  </a:txBody>
                  <a:tcPr marL="68474" marR="6847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9143" y="529769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0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143" y="4303068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1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524624" y="8842248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6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71461" y="7588478"/>
            <a:ext cx="631507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b) For question 21, </a:t>
            </a:r>
            <a:r>
              <a:rPr lang="en-US" sz="900" i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please   circle   the </a:t>
            </a:r>
            <a:r>
              <a:rPr lang="en-US" sz="9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most helpful thing</a:t>
            </a:r>
            <a:r>
              <a:rPr lang="en-US" sz="900" i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you do to resist hurting yourself.</a:t>
            </a:r>
            <a:endParaRPr lang="en-US" sz="900" i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2" name="Oval 11"/>
          <p:cNvSpPr/>
          <p:nvPr/>
        </p:nvSpPr>
        <p:spPr>
          <a:xfrm>
            <a:off x="1868132" y="7572233"/>
            <a:ext cx="417868" cy="24707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57850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3731721"/>
              </p:ext>
            </p:extLst>
          </p:nvPr>
        </p:nvGraphicFramePr>
        <p:xfrm>
          <a:off x="372405" y="457200"/>
          <a:ext cx="6324600" cy="719583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69012ECD-51FC-41F1-AA8D-1B2483CD663E}</a:tableStyleId>
              </a:tblPr>
              <a:tblGrid>
                <a:gridCol w="3733800"/>
                <a:gridCol w="2590800"/>
              </a:tblGrid>
              <a:tr h="536709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1028700" algn="l"/>
                          <a:tab pos="1600200" algn="l"/>
                          <a:tab pos="1828800" algn="l"/>
                          <a:tab pos="2114550" algn="l"/>
                          <a:tab pos="2628900" algn="l"/>
                          <a:tab pos="4400550" algn="l"/>
                          <a:tab pos="4857750" algn="l"/>
                          <a:tab pos="5314950" algn="l"/>
                          <a:tab pos="577215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How motivated are you at this time to stop self-injuring?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50800" cmpd="dbl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Not at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all          Somewhat          Extremely</a:t>
                      </a: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61722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Motivated          Motivated           Motivat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74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120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50800" cmpd="dbl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</a:t>
                      </a:r>
                      <a:r>
                        <a:rPr lang="en-GB" sz="800" b="0" dirty="0" smtClean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0            </a:t>
                      </a:r>
                      <a:r>
                        <a:rPr lang="en-GB" sz="800" b="0" dirty="0"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1           2          3           4</a:t>
                      </a:r>
                      <a:endParaRPr lang="en-US" sz="1100" b="0" dirty="0"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306949" y="1371600"/>
            <a:ext cx="63246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at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reatment(s) if any, have you received with the goal of reducing and/or eliminating your self-harm?</a:t>
            </a:r>
            <a:r>
              <a:rPr lang="en-GB" sz="900" b="1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endParaRPr lang="en-US" sz="9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i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  <a:r>
              <a:rPr lang="en-GB" sz="8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</a:t>
            </a:r>
            <a:r>
              <a:rPr lang="en-GB" sz="8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</a:t>
            </a:r>
            <a:r>
              <a:rPr lang="en-US" sz="1200" b="1" i="1" u="sng" dirty="0">
                <a:solidFill>
                  <a:prstClr val="black"/>
                </a:solidFill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GB" sz="8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</a:t>
            </a:r>
            <a:r>
              <a:rPr lang="en-GB" sz="8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ll items that apply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 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have not had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reatment	          I declined treatment	          Self help (e.g., self-help books, internet)</a:t>
            </a:r>
            <a:endParaRPr lang="en-US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ndividual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herapy	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school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counselling	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group therapy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family therapy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                      medication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specify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   ______________________________________</a:t>
            </a:r>
            <a:endParaRPr lang="en-GB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endParaRPr lang="en-GB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ther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specify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_______________________________________________________________________________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06948" y="2758559"/>
            <a:ext cx="6324601" cy="21852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9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endParaRPr lang="en-GB" sz="900" b="1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900" b="1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What </a:t>
            </a:r>
            <a:r>
              <a:rPr lang="en-GB" sz="900" b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treatment(s) if any, have you found the most helpful in reducing and/or eliminating your self-harm? </a:t>
            </a:r>
            <a:endParaRPr lang="en-US" sz="900" b="1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i="1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	</a:t>
            </a:r>
            <a:r>
              <a:rPr lang="en-GB" sz="8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</a:t>
            </a:r>
            <a:r>
              <a:rPr lang="en-GB" sz="8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</a:t>
            </a:r>
            <a:r>
              <a:rPr lang="en-US" sz="1200" b="1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√</a:t>
            </a:r>
            <a:r>
              <a:rPr lang="en-GB" sz="800" i="1" u="sng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) </a:t>
            </a:r>
            <a:r>
              <a:rPr lang="en-GB" sz="800" i="1" u="sng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all items that apply)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 have not had treatment            I declined treatment             Self help (e.g., self-help books, internet)</a:t>
            </a:r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</a:t>
            </a:r>
          </a:p>
          <a:p>
            <a:pPr>
              <a:lnSpc>
                <a:spcPct val="150000"/>
              </a:lnSpc>
            </a:pP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individual therapy                       school counselling                group therapy</a:t>
            </a:r>
            <a:endParaRPr lang="en-US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200000"/>
              </a:lnSpc>
            </a:pP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         family therapy                           medication (please specify)     _________________________________________ </a:t>
            </a:r>
          </a:p>
          <a:p>
            <a:pPr>
              <a:lnSpc>
                <a:spcPct val="200000"/>
              </a:lnSpc>
            </a:pPr>
            <a:endParaRPr lang="en-GB" sz="800" dirty="0" smtClean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>
              <a:lnSpc>
                <a:spcPct val="150000"/>
              </a:lnSpc>
            </a:pP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other </a:t>
            </a:r>
            <a:r>
              <a:rPr lang="en-GB" sz="800" dirty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(please specify) </a:t>
            </a:r>
            <a:r>
              <a:rPr lang="en-GB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___________________________________________________________________________</a:t>
            </a:r>
          </a:p>
          <a:p>
            <a:pPr>
              <a:lnSpc>
                <a:spcPct val="150000"/>
              </a:lnSpc>
            </a:pP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9023922"/>
              </p:ext>
            </p:extLst>
          </p:nvPr>
        </p:nvGraphicFramePr>
        <p:xfrm>
          <a:off x="372405" y="4803606"/>
          <a:ext cx="6324600" cy="544982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3733800"/>
                <a:gridCol w="2590800"/>
              </a:tblGrid>
              <a:tr h="29083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  <a:tab pos="1028700" algn="l"/>
                          <a:tab pos="1600200" algn="l"/>
                          <a:tab pos="1828800" algn="l"/>
                          <a:tab pos="2114550" algn="l"/>
                          <a:tab pos="2628900" algn="l"/>
                          <a:tab pos="4400550" algn="l"/>
                          <a:tab pos="4857750" algn="l"/>
                          <a:tab pos="5314950" algn="l"/>
                          <a:tab pos="577215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I feel that this questionnaire has fully described my experience of Self-Injury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228600" marR="0" indent="-49911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530350" algn="l"/>
                          <a:tab pos="1885950" algn="l"/>
                          <a:tab pos="2171700" algn="l"/>
                          <a:tab pos="2514600" algn="l"/>
                          <a:tab pos="3330575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rongly            Somewhat </a:t>
                      </a:r>
                      <a:r>
                        <a:rPr lang="en-GB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Strongly</a:t>
                      </a:r>
                    </a:p>
                    <a:p>
                      <a:pPr marL="228600" marR="0" indent="-49911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530350" algn="l"/>
                          <a:tab pos="1885950" algn="l"/>
                          <a:tab pos="2171700" algn="l"/>
                          <a:tab pos="2514600" algn="l"/>
                          <a:tab pos="3330575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Disagree               Agree     </a:t>
                      </a:r>
                      <a:r>
                        <a:rPr lang="en-GB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       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Agree      </a:t>
                      </a: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highlight>
                            <a:srgbClr val="FF0000"/>
                          </a:highlight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 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88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0" algn="l"/>
                          <a:tab pos="285750" algn="l"/>
                          <a:tab pos="914400" algn="l"/>
                          <a:tab pos="1371600" algn="l"/>
                          <a:tab pos="1885950" algn="l"/>
                          <a:tab pos="2171700" algn="l"/>
                          <a:tab pos="25146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lang="en-GB" sz="80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800" baseline="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</a:t>
                      </a:r>
                      <a:r>
                        <a:rPr lang="en-GB" sz="800" dirty="0" smtClean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    </a:t>
                      </a:r>
                      <a:r>
                        <a:rPr lang="en-GB" sz="800" b="0" dirty="0"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  <a:cs typeface="Meiryo" panose="020B0604030504040204" pitchFamily="34" charset="-128"/>
                        </a:rPr>
                        <a:t>0            1           2          3           4</a:t>
                      </a:r>
                      <a:endParaRPr lang="en-US" sz="800" b="0" dirty="0">
                        <a:solidFill>
                          <a:schemeClr val="tx1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  <a:cs typeface="Meiryo" panose="020B0604030504040204" pitchFamily="34" charset="-128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360377" y="5486400"/>
            <a:ext cx="5830442" cy="507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</a:pPr>
            <a:r>
              <a:rPr kumimoji="0" lang="en-GB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Is there anything else you would like to share with us regarding your self-injury behaviour?</a:t>
            </a:r>
            <a:endParaRPr kumimoji="0" lang="en-US" altLang="en-US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-171450" algn="l"/>
                <a:tab pos="269875" algn="l"/>
                <a:tab pos="914400" algn="l"/>
                <a:tab pos="1371600" algn="l"/>
                <a:tab pos="1885950" algn="l"/>
                <a:tab pos="2251075" algn="l"/>
                <a:tab pos="2514600" algn="l"/>
                <a:tab pos="3657600" algn="l"/>
                <a:tab pos="4114800" algn="l"/>
                <a:tab pos="4572000" algn="l"/>
                <a:tab pos="5029200" algn="l"/>
              </a:tabLst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0377" y="5740315"/>
            <a:ext cx="63246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_</a:t>
            </a:r>
            <a:endParaRPr lang="en-US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91641" y="365707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91641" y="385900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91641" y="4061202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2125005" y="3644368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125005" y="385900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125005" y="4061202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649005" y="3657070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649005" y="3874873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91641" y="195163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491641" y="2182141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491641" y="2390419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2307885" y="195163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2307885" y="2376273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2307885" y="2164818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4182405" y="1951636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182405" y="2164818"/>
            <a:ext cx="182880" cy="182880"/>
          </a:xfrm>
          <a:prstGeom prst="rect">
            <a:avLst/>
          </a:prstGeom>
          <a:ln w="12700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76749" y="395735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2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6749" y="1371600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3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6749" y="3026664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4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6749" y="4754880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5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6749" y="5465624"/>
            <a:ext cx="363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26.</a:t>
            </a:r>
            <a:endParaRPr lang="en-US" sz="8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553200" y="8842248"/>
            <a:ext cx="304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Meiryo" panose="020B0604030504040204" pitchFamily="34" charset="-128"/>
                <a:ea typeface="Meiryo" panose="020B0604030504040204" pitchFamily="34" charset="-128"/>
                <a:cs typeface="Meiryo" panose="020B0604030504040204" pitchFamily="34" charset="-128"/>
              </a:rPr>
              <a:t>7</a:t>
            </a:r>
            <a:endParaRPr lang="en-US" sz="900" dirty="0">
              <a:latin typeface="Meiryo" panose="020B0604030504040204" pitchFamily="34" charset="-128"/>
              <a:ea typeface="Meiryo" panose="020B0604030504040204" pitchFamily="34" charset="-128"/>
              <a:cs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541733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8"/>
  <p:tag name="MMPROD_UIDATA" val="&lt;database version=&quot;6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Slide 1&quot;/&gt;&lt;property id=&quot;20307&quot; value=&quot;259&quot;/&gt;&lt;/object&gt;&lt;object type=&quot;3&quot; unique_id=&quot;10005&quot;&gt;&lt;property id=&quot;20148&quot; value=&quot;5&quot;/&gt;&lt;property id=&quot;20300&quot; value=&quot;Slide 2&quot;/&gt;&lt;property id=&quot;20307&quot; value=&quot;257&quot;/&gt;&lt;/object&gt;&lt;object type=&quot;3&quot; unique_id=&quot;10006&quot;&gt;&lt;property id=&quot;20148&quot; value=&quot;5&quot;/&gt;&lt;property id=&quot;20300&quot; value=&quot;Slide 3&quot;/&gt;&lt;property id=&quot;20307&quot; value=&quot;268&quot;/&gt;&lt;/object&gt;&lt;object type=&quot;3&quot; unique_id=&quot;10007&quot;&gt;&lt;property id=&quot;20148&quot; value=&quot;5&quot;/&gt;&lt;property id=&quot;20300&quot; value=&quot;Slide 4&quot;/&gt;&lt;property id=&quot;20307&quot; value=&quot;262&quot;/&gt;&lt;/object&gt;&lt;object type=&quot;3&quot; unique_id=&quot;10008&quot;&gt;&lt;property id=&quot;20148&quot; value=&quot;5&quot;/&gt;&lt;property id=&quot;20300&quot; value=&quot;Slide 5&quot;/&gt;&lt;property id=&quot;20307&quot; value=&quot;265&quot;/&gt;&lt;/object&gt;&lt;object type=&quot;3&quot; unique_id=&quot;10009&quot;&gt;&lt;property id=&quot;20148&quot; value=&quot;5&quot;/&gt;&lt;property id=&quot;20300&quot; value=&quot;Slide 6&quot;/&gt;&lt;property id=&quot;20307&quot; value=&quot;266&quot;/&gt;&lt;/object&gt;&lt;object type=&quot;3&quot; unique_id=&quot;10010&quot;&gt;&lt;property id=&quot;20148&quot; value=&quot;5&quot;/&gt;&lt;property id=&quot;20300&quot; value=&quot;Slide 7&quot;/&gt;&lt;property id=&quot;20307&quot; value=&quot;267&quot;/&gt;&lt;/object&gt;&lt;/object&gt;&lt;/object&gt;&lt;/database&gt;"/>
</p:tagLst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rigin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rigin">
      <a:majorFont>
        <a:latin typeface="Bookman Old Style"/>
        <a:ea typeface=""/>
        <a:cs typeface=""/>
        <a:font script="Grek" typeface="Cambria"/>
        <a:font script="Cyrl" typeface="Cambria"/>
        <a:font script="Jpan" typeface="HG明朝E"/>
        <a:font script="Hang" typeface="돋움"/>
        <a:font script="Hans" typeface="宋体"/>
        <a:font script="Hant" typeface="標楷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Gill Sans MT"/>
        <a:ea typeface=""/>
        <a:cs typeface=""/>
        <a:font script="Grek" typeface="Calibri"/>
        <a:font script="Cyrl" typeface="Calibri"/>
        <a:font script="Jpan" typeface="ＭＳ Ｐゴシック"/>
        <a:font script="Hang" typeface="맑은 고딕"/>
        <a:font script="Hans" typeface="华文新魏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rigin">
      <a:fillStyleLst>
        <a:solidFill>
          <a:schemeClr val="phClr"/>
        </a:solidFill>
        <a:gradFill rotWithShape="1">
          <a:gsLst>
            <a:gs pos="0">
              <a:schemeClr val="phClr">
                <a:tint val="45000"/>
                <a:satMod val="200000"/>
              </a:schemeClr>
            </a:gs>
            <a:gs pos="30000">
              <a:schemeClr val="phClr">
                <a:tint val="61000"/>
                <a:satMod val="200000"/>
              </a:schemeClr>
            </a:gs>
            <a:gs pos="45000">
              <a:schemeClr val="phClr">
                <a:tint val="66000"/>
                <a:satMod val="200000"/>
              </a:schemeClr>
            </a:gs>
            <a:gs pos="55000">
              <a:schemeClr val="phClr">
                <a:tint val="66000"/>
                <a:satMod val="200000"/>
              </a:schemeClr>
            </a:gs>
            <a:gs pos="73000">
              <a:schemeClr val="phClr">
                <a:tint val="61000"/>
                <a:satMod val="200000"/>
              </a:schemeClr>
            </a:gs>
            <a:gs pos="100000">
              <a:schemeClr val="phClr">
                <a:tint val="45000"/>
                <a:satMod val="200000"/>
              </a:schemeClr>
            </a:gs>
          </a:gsLst>
          <a:lin ang="950000" scaled="1"/>
        </a:gradFill>
        <a:gradFill rotWithShape="1">
          <a:gsLst>
            <a:gs pos="0">
              <a:schemeClr val="phClr">
                <a:shade val="63000"/>
              </a:schemeClr>
            </a:gs>
            <a:gs pos="30000">
              <a:schemeClr val="phClr">
                <a:shade val="90000"/>
                <a:satMod val="110000"/>
              </a:schemeClr>
            </a:gs>
            <a:gs pos="45000">
              <a:schemeClr val="phClr">
                <a:shade val="100000"/>
                <a:satMod val="118000"/>
              </a:schemeClr>
            </a:gs>
            <a:gs pos="55000">
              <a:schemeClr val="phClr">
                <a:shade val="100000"/>
                <a:satMod val="118000"/>
              </a:schemeClr>
            </a:gs>
            <a:gs pos="73000">
              <a:schemeClr val="phClr">
                <a:shade val="90000"/>
                <a:satMod val="110000"/>
              </a:schemeClr>
            </a:gs>
            <a:gs pos="100000">
              <a:schemeClr val="phClr">
                <a:shade val="63000"/>
              </a:schemeClr>
            </a:gs>
          </a:gsLst>
          <a:lin ang="950000" scaled="1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43000" dir="5400000" rotWithShape="0">
              <a:srgbClr val="000000">
                <a:alpha val="40000"/>
              </a:srgbClr>
            </a:outerShdw>
          </a:effectLst>
          <a:scene3d>
            <a:camera prst="orthographicFront" fov="0">
              <a:rot lat="0" lon="0" rev="0"/>
            </a:camera>
            <a:lightRig rig="balanced" dir="t">
              <a:rot lat="0" lon="0" rev="0"/>
            </a:lightRig>
          </a:scene3d>
          <a:sp3d prstMaterial="matte">
            <a:bevelT w="0" h="0"/>
            <a:contourClr>
              <a:schemeClr val="phClr">
                <a:tint val="100000"/>
                <a:shade val="100000"/>
                <a:hueMod val="100000"/>
                <a:satMod val="100000"/>
              </a:schemeClr>
            </a:contourClr>
          </a:sp3d>
        </a:effectStyle>
        <a:effectStyle>
          <a:effectLst>
            <a:outerShdw blurRad="50800" dist="25400" dir="5400000" rotWithShape="0">
              <a:srgbClr val="000000">
                <a:alpha val="50000"/>
              </a:srgbClr>
            </a:outerShdw>
          </a:effectLst>
          <a:scene3d>
            <a:camera prst="orthographicFront" fov="0">
              <a:rot lat="0" lon="0" rev="0"/>
            </a:camera>
            <a:lightRig rig="soft" dir="t">
              <a:rot lat="0" lon="0" rev="2700000"/>
            </a:lightRig>
          </a:scene3d>
          <a:sp3d prstMaterial="matte">
            <a:bevelT w="50800" h="50800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60000"/>
                <a:satMod val="300000"/>
              </a:schemeClr>
            </a:gs>
            <a:gs pos="30000">
              <a:schemeClr val="phClr">
                <a:shade val="80000"/>
                <a:satMod val="230000"/>
              </a:schemeClr>
            </a:gs>
            <a:gs pos="100000">
              <a:schemeClr val="phClr">
                <a:tint val="97000"/>
                <a:satMod val="22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6000"/>
                <a:satMod val="120000"/>
              </a:schemeClr>
              <a:schemeClr val="phClr">
                <a:tint val="90000"/>
              </a:schemeClr>
            </a:duotone>
          </a:blip>
          <a:tile tx="0" ty="0" sx="35000" sy="40000" flip="x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rigin</Template>
  <TotalTime>3105</TotalTime>
  <Words>1915</Words>
  <Application>Microsoft Macintosh PowerPoint</Application>
  <PresentationFormat>Letter Paper (8.5x11 in)</PresentationFormat>
  <Paragraphs>453</Paragraphs>
  <Slides>7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rigi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E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Dylan</dc:creator>
  <cp:lastModifiedBy>Christine  Levesque</cp:lastModifiedBy>
  <cp:revision>172</cp:revision>
  <cp:lastPrinted>2015-05-28T16:35:46Z</cp:lastPrinted>
  <dcterms:created xsi:type="dcterms:W3CDTF">2014-03-10T14:12:55Z</dcterms:created>
  <dcterms:modified xsi:type="dcterms:W3CDTF">2015-06-02T15:52:50Z</dcterms:modified>
</cp:coreProperties>
</file>